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0801350" cy="9001125"/>
  <p:notesSz cx="6858000" cy="9144000"/>
  <p:defaultTextStyle>
    <a:defPPr>
      <a:defRPr lang="zh-CN"/>
    </a:defPPr>
    <a:lvl1pPr marL="0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576072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152144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1728216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2304288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2880360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3456432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4032504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4608576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1410" y="-84"/>
      </p:cViewPr>
      <p:guideLst>
        <p:guide orient="horz" pos="2835"/>
        <p:guide pos="34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03%20&#30740;&#31350;\&#25991;&#31456;&#35797;&#20889;&#20316;\X1%20&#38271;&#27743;&#40060;&#31867;&#32928;&#36947;&#24494;&#29983;&#29289;\&#38271;&#27743;&#40060;&#31867;&#32928;&#36947;microHI&#22522;&#20934;&#20540;\&#34920;&#22411;&#39044;&#27979;&#32467;&#26524;&#34920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03%20&#30740;&#31350;\&#25991;&#31456;&#35797;&#20889;&#20316;\X1%20&#38271;&#27743;&#40060;&#31867;&#32928;&#36947;&#24494;&#29983;&#29289;\&#38271;&#27743;&#40060;&#31867;&#32928;&#36947;microHI&#22522;&#20934;&#20540;\&#34920;&#22411;&#39044;&#27979;&#32467;&#26524;&#3492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03%20&#30740;&#31350;\&#25991;&#31456;&#35797;&#20889;&#20316;\X1%20&#38271;&#27743;&#40060;&#31867;&#32928;&#36947;&#24494;&#29983;&#29289;\&#38271;&#27743;&#40060;&#31867;&#32928;&#36947;microHI&#22522;&#20934;&#20540;\&#34920;&#22411;&#39044;&#27979;&#32467;&#26524;&#3492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600" b="1" i="0" u="none" strike="noStrike" baseline="0" dirty="0">
                <a:effectLst/>
              </a:rPr>
              <a:t>Percent of the microbes with the phenotype of </a:t>
            </a:r>
            <a:r>
              <a:rPr lang="en-US" altLang="en-US" sz="1600" dirty="0"/>
              <a:t>Potentially Pathogenic </a:t>
            </a:r>
            <a:r>
              <a:rPr lang="en-US" altLang="zh-CN" sz="1600" b="1" i="0" baseline="0" dirty="0">
                <a:effectLst/>
              </a:rPr>
              <a:t>in each sample</a:t>
            </a:r>
            <a:endParaRPr lang="zh-CN" altLang="zh-CN" sz="1600" dirty="0">
              <a:effectLst/>
            </a:endParaRP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5.2844988242640674E-2"/>
          <c:y val="0.19480351414406533"/>
          <c:w val="0.93352428065450932"/>
          <c:h val="0.374910688247302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表型预测结果表!$A$7</c:f>
              <c:strCache>
                <c:ptCount val="1"/>
                <c:pt idx="0">
                  <c:v>Potentially_Pathogenic</c:v>
                </c:pt>
              </c:strCache>
            </c:strRef>
          </c:tx>
          <c:invertIfNegative val="0"/>
          <c:cat>
            <c:strRef>
              <c:f>表型预测结果表!$B$6:$IK$6</c:f>
              <c:strCache>
                <c:ptCount val="244"/>
                <c:pt idx="0">
                  <c:v>AN20220701</c:v>
                </c:pt>
                <c:pt idx="1">
                  <c:v>AN20220702</c:v>
                </c:pt>
                <c:pt idx="2">
                  <c:v>AN20220703</c:v>
                </c:pt>
                <c:pt idx="3">
                  <c:v>AN20220704</c:v>
                </c:pt>
                <c:pt idx="4">
                  <c:v>AN20220705</c:v>
                </c:pt>
                <c:pt idx="5">
                  <c:v>CB20220701</c:v>
                </c:pt>
                <c:pt idx="6">
                  <c:v>CB20220702</c:v>
                </c:pt>
                <c:pt idx="7">
                  <c:v>CB20220703</c:v>
                </c:pt>
                <c:pt idx="8">
                  <c:v>CB20220704</c:v>
                </c:pt>
                <c:pt idx="9">
                  <c:v>CB20220705</c:v>
                </c:pt>
                <c:pt idx="10">
                  <c:v>CB20220706</c:v>
                </c:pt>
                <c:pt idx="11">
                  <c:v>CB20220707</c:v>
                </c:pt>
                <c:pt idx="12">
                  <c:v>CB20220708</c:v>
                </c:pt>
                <c:pt idx="13">
                  <c:v>CB20220709</c:v>
                </c:pt>
                <c:pt idx="14">
                  <c:v>CB20220710</c:v>
                </c:pt>
                <c:pt idx="15">
                  <c:v>CB20220711</c:v>
                </c:pt>
                <c:pt idx="16">
                  <c:v>CB20220712</c:v>
                </c:pt>
                <c:pt idx="17">
                  <c:v>CB20220713</c:v>
                </c:pt>
                <c:pt idx="18">
                  <c:v>CB20220714</c:v>
                </c:pt>
                <c:pt idx="19">
                  <c:v>CB20220715</c:v>
                </c:pt>
                <c:pt idx="20">
                  <c:v>CB20220716</c:v>
                </c:pt>
                <c:pt idx="21">
                  <c:v>CB20220717</c:v>
                </c:pt>
                <c:pt idx="22">
                  <c:v>CB20220718</c:v>
                </c:pt>
                <c:pt idx="23">
                  <c:v>CB20220719</c:v>
                </c:pt>
                <c:pt idx="24">
                  <c:v>CB20220720</c:v>
                </c:pt>
                <c:pt idx="25">
                  <c:v>CB20220721</c:v>
                </c:pt>
                <c:pt idx="26">
                  <c:v>CB20220722</c:v>
                </c:pt>
                <c:pt idx="27">
                  <c:v>CB20220723</c:v>
                </c:pt>
                <c:pt idx="28">
                  <c:v>CB20220724</c:v>
                </c:pt>
                <c:pt idx="29">
                  <c:v>CB20220725</c:v>
                </c:pt>
                <c:pt idx="30">
                  <c:v>CB20220726</c:v>
                </c:pt>
                <c:pt idx="31">
                  <c:v>CB20220727</c:v>
                </c:pt>
                <c:pt idx="32">
                  <c:v>CB20220728</c:v>
                </c:pt>
                <c:pt idx="33">
                  <c:v>CB20220729</c:v>
                </c:pt>
                <c:pt idx="34">
                  <c:v>CB20220730</c:v>
                </c:pt>
                <c:pt idx="35">
                  <c:v>CB20220731</c:v>
                </c:pt>
                <c:pt idx="36">
                  <c:v>CH20220701</c:v>
                </c:pt>
                <c:pt idx="37">
                  <c:v>CH20220702</c:v>
                </c:pt>
                <c:pt idx="38">
                  <c:v>CH20220703</c:v>
                </c:pt>
                <c:pt idx="39">
                  <c:v>CH20220704</c:v>
                </c:pt>
                <c:pt idx="40">
                  <c:v>CH20220705</c:v>
                </c:pt>
                <c:pt idx="41">
                  <c:v>CH20220706</c:v>
                </c:pt>
                <c:pt idx="42">
                  <c:v>CH20220707</c:v>
                </c:pt>
                <c:pt idx="43">
                  <c:v>CH20220708</c:v>
                </c:pt>
                <c:pt idx="44">
                  <c:v>CH20220709</c:v>
                </c:pt>
                <c:pt idx="45">
                  <c:v>CH20220710</c:v>
                </c:pt>
                <c:pt idx="46">
                  <c:v>CH20220711</c:v>
                </c:pt>
                <c:pt idx="47">
                  <c:v>CH20220712</c:v>
                </c:pt>
                <c:pt idx="48">
                  <c:v>CH20220713</c:v>
                </c:pt>
                <c:pt idx="49">
                  <c:v>CH20220714</c:v>
                </c:pt>
                <c:pt idx="50">
                  <c:v>CH20220715</c:v>
                </c:pt>
                <c:pt idx="51">
                  <c:v>CH20220716</c:v>
                </c:pt>
                <c:pt idx="52">
                  <c:v>CH20220717</c:v>
                </c:pt>
                <c:pt idx="53">
                  <c:v>CH20220718</c:v>
                </c:pt>
                <c:pt idx="54">
                  <c:v>CH20220719</c:v>
                </c:pt>
                <c:pt idx="55">
                  <c:v>CH20220720</c:v>
                </c:pt>
                <c:pt idx="56">
                  <c:v>CH20220721</c:v>
                </c:pt>
                <c:pt idx="57">
                  <c:v>CH20220722</c:v>
                </c:pt>
                <c:pt idx="58">
                  <c:v>CH20220723</c:v>
                </c:pt>
                <c:pt idx="59">
                  <c:v>CH20220724</c:v>
                </c:pt>
                <c:pt idx="60">
                  <c:v>CH20220725</c:v>
                </c:pt>
                <c:pt idx="61">
                  <c:v>CH20220726</c:v>
                </c:pt>
                <c:pt idx="62">
                  <c:v>CH20220727</c:v>
                </c:pt>
                <c:pt idx="63">
                  <c:v>CH20220728</c:v>
                </c:pt>
                <c:pt idx="64">
                  <c:v>CH20220729</c:v>
                </c:pt>
                <c:pt idx="65">
                  <c:v>CH20220730</c:v>
                </c:pt>
                <c:pt idx="66">
                  <c:v>CH20220731</c:v>
                </c:pt>
                <c:pt idx="67">
                  <c:v>CH20220732</c:v>
                </c:pt>
                <c:pt idx="68">
                  <c:v>CH20220733</c:v>
                </c:pt>
                <c:pt idx="69">
                  <c:v>CH20220734</c:v>
                </c:pt>
                <c:pt idx="70">
                  <c:v>CH20220735</c:v>
                </c:pt>
                <c:pt idx="71">
                  <c:v>HM20220701</c:v>
                </c:pt>
                <c:pt idx="72">
                  <c:v>HM20220702</c:v>
                </c:pt>
                <c:pt idx="73">
                  <c:v>HM20220703</c:v>
                </c:pt>
                <c:pt idx="74">
                  <c:v>HM20220704</c:v>
                </c:pt>
                <c:pt idx="75">
                  <c:v>LC20220701</c:v>
                </c:pt>
                <c:pt idx="76">
                  <c:v>LC20220702</c:v>
                </c:pt>
                <c:pt idx="77">
                  <c:v>LC20220703</c:v>
                </c:pt>
                <c:pt idx="78">
                  <c:v>LC20220704</c:v>
                </c:pt>
                <c:pt idx="79">
                  <c:v>LC20220705</c:v>
                </c:pt>
                <c:pt idx="80">
                  <c:v>LC20220706</c:v>
                </c:pt>
                <c:pt idx="81">
                  <c:v>LC20220707</c:v>
                </c:pt>
                <c:pt idx="82">
                  <c:v>LC20220708</c:v>
                </c:pt>
                <c:pt idx="83">
                  <c:v>LC20220709</c:v>
                </c:pt>
                <c:pt idx="84">
                  <c:v>LC20220710</c:v>
                </c:pt>
                <c:pt idx="85">
                  <c:v>LC20220711</c:v>
                </c:pt>
                <c:pt idx="86">
                  <c:v>LC20220712</c:v>
                </c:pt>
                <c:pt idx="87">
                  <c:v>LC20220713</c:v>
                </c:pt>
                <c:pt idx="88">
                  <c:v>LC20220714</c:v>
                </c:pt>
                <c:pt idx="89">
                  <c:v>LC20220715</c:v>
                </c:pt>
                <c:pt idx="90">
                  <c:v>LC20220716</c:v>
                </c:pt>
                <c:pt idx="91">
                  <c:v>LC20220717</c:v>
                </c:pt>
                <c:pt idx="92">
                  <c:v>LC20220718</c:v>
                </c:pt>
                <c:pt idx="93">
                  <c:v>LC20220719</c:v>
                </c:pt>
                <c:pt idx="94">
                  <c:v>LC20220720</c:v>
                </c:pt>
                <c:pt idx="95">
                  <c:v>LC20220721</c:v>
                </c:pt>
                <c:pt idx="96">
                  <c:v>LC20220722</c:v>
                </c:pt>
                <c:pt idx="97">
                  <c:v>LC20220723</c:v>
                </c:pt>
                <c:pt idx="98">
                  <c:v>LC20220724</c:v>
                </c:pt>
                <c:pt idx="99">
                  <c:v>LC20220725</c:v>
                </c:pt>
                <c:pt idx="100">
                  <c:v>LC20220726</c:v>
                </c:pt>
                <c:pt idx="101">
                  <c:v>LC20220727</c:v>
                </c:pt>
                <c:pt idx="102">
                  <c:v>LC20220728</c:v>
                </c:pt>
                <c:pt idx="103">
                  <c:v>LC20220729</c:v>
                </c:pt>
                <c:pt idx="104">
                  <c:v>LC20220730</c:v>
                </c:pt>
                <c:pt idx="105">
                  <c:v>LC20220731</c:v>
                </c:pt>
                <c:pt idx="106">
                  <c:v>LL20220701</c:v>
                </c:pt>
                <c:pt idx="107">
                  <c:v>LL20220702</c:v>
                </c:pt>
                <c:pt idx="108">
                  <c:v>LL20220703</c:v>
                </c:pt>
                <c:pt idx="109">
                  <c:v>LL20220704</c:v>
                </c:pt>
                <c:pt idx="110">
                  <c:v>LL20220705</c:v>
                </c:pt>
                <c:pt idx="111">
                  <c:v>LL20220706</c:v>
                </c:pt>
                <c:pt idx="112">
                  <c:v>LL20220707</c:v>
                </c:pt>
                <c:pt idx="113">
                  <c:v>LL20220708</c:v>
                </c:pt>
                <c:pt idx="114">
                  <c:v>LL20220709</c:v>
                </c:pt>
                <c:pt idx="115">
                  <c:v>LL20220710</c:v>
                </c:pt>
                <c:pt idx="116">
                  <c:v>LL20220711</c:v>
                </c:pt>
                <c:pt idx="117">
                  <c:v>LL20220712</c:v>
                </c:pt>
                <c:pt idx="118">
                  <c:v>LL20220713</c:v>
                </c:pt>
                <c:pt idx="119">
                  <c:v>LL20220714</c:v>
                </c:pt>
                <c:pt idx="120">
                  <c:v>LL20220715</c:v>
                </c:pt>
                <c:pt idx="121">
                  <c:v>LL20220716</c:v>
                </c:pt>
                <c:pt idx="122">
                  <c:v>LL20220717</c:v>
                </c:pt>
                <c:pt idx="123">
                  <c:v>LL20220718</c:v>
                </c:pt>
                <c:pt idx="124">
                  <c:v>LL20220719</c:v>
                </c:pt>
                <c:pt idx="125">
                  <c:v>LL20220720</c:v>
                </c:pt>
                <c:pt idx="126">
                  <c:v>LL20220721</c:v>
                </c:pt>
                <c:pt idx="127">
                  <c:v>LL20220722</c:v>
                </c:pt>
                <c:pt idx="128">
                  <c:v>LL20220723</c:v>
                </c:pt>
                <c:pt idx="129">
                  <c:v>LL20220724</c:v>
                </c:pt>
                <c:pt idx="130">
                  <c:v>LL20220725</c:v>
                </c:pt>
                <c:pt idx="131">
                  <c:v>LL20220726</c:v>
                </c:pt>
                <c:pt idx="132">
                  <c:v>LL20220727</c:v>
                </c:pt>
                <c:pt idx="133">
                  <c:v>LL20220728</c:v>
                </c:pt>
                <c:pt idx="134">
                  <c:v>LL20220729</c:v>
                </c:pt>
                <c:pt idx="135">
                  <c:v>LL20220730</c:v>
                </c:pt>
                <c:pt idx="136">
                  <c:v>LL20220731</c:v>
                </c:pt>
                <c:pt idx="137">
                  <c:v>LL20220732</c:v>
                </c:pt>
                <c:pt idx="138">
                  <c:v>LL20220733</c:v>
                </c:pt>
                <c:pt idx="139">
                  <c:v>LL20220734</c:v>
                </c:pt>
                <c:pt idx="140">
                  <c:v>LL20220735</c:v>
                </c:pt>
                <c:pt idx="141">
                  <c:v>LL20220736</c:v>
                </c:pt>
                <c:pt idx="142">
                  <c:v>LL20220737</c:v>
                </c:pt>
                <c:pt idx="143">
                  <c:v>LL20220738</c:v>
                </c:pt>
                <c:pt idx="144">
                  <c:v>LL20220739</c:v>
                </c:pt>
                <c:pt idx="145">
                  <c:v>LL20220740</c:v>
                </c:pt>
                <c:pt idx="146">
                  <c:v>LL20220741</c:v>
                </c:pt>
                <c:pt idx="147">
                  <c:v>PF20220701</c:v>
                </c:pt>
                <c:pt idx="148">
                  <c:v>PF20220702</c:v>
                </c:pt>
                <c:pt idx="149">
                  <c:v>PF20220703</c:v>
                </c:pt>
                <c:pt idx="150">
                  <c:v>PF20220704</c:v>
                </c:pt>
                <c:pt idx="151">
                  <c:v>PF20220705</c:v>
                </c:pt>
                <c:pt idx="152">
                  <c:v>PF20220706</c:v>
                </c:pt>
                <c:pt idx="153">
                  <c:v>PF20220707</c:v>
                </c:pt>
                <c:pt idx="154">
                  <c:v>PF20220708</c:v>
                </c:pt>
                <c:pt idx="155">
                  <c:v>PF20220709</c:v>
                </c:pt>
                <c:pt idx="156">
                  <c:v>PF20220710</c:v>
                </c:pt>
                <c:pt idx="157">
                  <c:v>PF20220711</c:v>
                </c:pt>
                <c:pt idx="158">
                  <c:v>PF20220712</c:v>
                </c:pt>
                <c:pt idx="159">
                  <c:v>PF20220713</c:v>
                </c:pt>
                <c:pt idx="160">
                  <c:v>PF20220714</c:v>
                </c:pt>
                <c:pt idx="161">
                  <c:v>PF20220715</c:v>
                </c:pt>
                <c:pt idx="162">
                  <c:v>PF20220716</c:v>
                </c:pt>
                <c:pt idx="163">
                  <c:v>PN20220701</c:v>
                </c:pt>
                <c:pt idx="164">
                  <c:v>PN20220702</c:v>
                </c:pt>
                <c:pt idx="165">
                  <c:v>PN20220703</c:v>
                </c:pt>
                <c:pt idx="166">
                  <c:v>PN20220704</c:v>
                </c:pt>
                <c:pt idx="167">
                  <c:v>PN20220705</c:v>
                </c:pt>
                <c:pt idx="168">
                  <c:v>PN20220706</c:v>
                </c:pt>
                <c:pt idx="169">
                  <c:v>PN20220707</c:v>
                </c:pt>
                <c:pt idx="170">
                  <c:v>PN20220708</c:v>
                </c:pt>
                <c:pt idx="171">
                  <c:v>PN20220709</c:v>
                </c:pt>
                <c:pt idx="172">
                  <c:v>PN20220710</c:v>
                </c:pt>
                <c:pt idx="173">
                  <c:v>PN20220711</c:v>
                </c:pt>
                <c:pt idx="174">
                  <c:v>PT20220701</c:v>
                </c:pt>
                <c:pt idx="175">
                  <c:v>PT20220702</c:v>
                </c:pt>
                <c:pt idx="176">
                  <c:v>PT20220703</c:v>
                </c:pt>
                <c:pt idx="177">
                  <c:v>PT20220704</c:v>
                </c:pt>
                <c:pt idx="178">
                  <c:v>PT20220705</c:v>
                </c:pt>
                <c:pt idx="179">
                  <c:v>PT20220706</c:v>
                </c:pt>
                <c:pt idx="180">
                  <c:v>PV20220701</c:v>
                </c:pt>
                <c:pt idx="181">
                  <c:v>PV20220702</c:v>
                </c:pt>
                <c:pt idx="182">
                  <c:v>PV20220703</c:v>
                </c:pt>
                <c:pt idx="183">
                  <c:v>PV20220704</c:v>
                </c:pt>
                <c:pt idx="184">
                  <c:v>SC20220701</c:v>
                </c:pt>
                <c:pt idx="185">
                  <c:v>SC20220702</c:v>
                </c:pt>
                <c:pt idx="186">
                  <c:v>SC20220703</c:v>
                </c:pt>
                <c:pt idx="187">
                  <c:v>SC20220704</c:v>
                </c:pt>
                <c:pt idx="188">
                  <c:v>SC20220705</c:v>
                </c:pt>
                <c:pt idx="189">
                  <c:v>SC20220706</c:v>
                </c:pt>
                <c:pt idx="190">
                  <c:v>SC20220707</c:v>
                </c:pt>
                <c:pt idx="191">
                  <c:v>SC20220708</c:v>
                </c:pt>
                <c:pt idx="192">
                  <c:v>SC20220709</c:v>
                </c:pt>
                <c:pt idx="193">
                  <c:v>SK20220701</c:v>
                </c:pt>
                <c:pt idx="194">
                  <c:v>SK20220702</c:v>
                </c:pt>
                <c:pt idx="195">
                  <c:v>SK20220703</c:v>
                </c:pt>
                <c:pt idx="196">
                  <c:v>SK20220704</c:v>
                </c:pt>
                <c:pt idx="197">
                  <c:v>SK20220705</c:v>
                </c:pt>
                <c:pt idx="198">
                  <c:v>SM20220701</c:v>
                </c:pt>
                <c:pt idx="199">
                  <c:v>SM20220702</c:v>
                </c:pt>
                <c:pt idx="200">
                  <c:v>XA20220701</c:v>
                </c:pt>
                <c:pt idx="201">
                  <c:v>XA20220702</c:v>
                </c:pt>
                <c:pt idx="202">
                  <c:v>XA20220703</c:v>
                </c:pt>
                <c:pt idx="203">
                  <c:v>XA20220704</c:v>
                </c:pt>
                <c:pt idx="204">
                  <c:v>XA20220705</c:v>
                </c:pt>
                <c:pt idx="205">
                  <c:v>XA20220706</c:v>
                </c:pt>
                <c:pt idx="206">
                  <c:v>XA20220707</c:v>
                </c:pt>
                <c:pt idx="207">
                  <c:v>XA20220708</c:v>
                </c:pt>
                <c:pt idx="208">
                  <c:v>XA20220709</c:v>
                </c:pt>
                <c:pt idx="209">
                  <c:v>XA20220710</c:v>
                </c:pt>
                <c:pt idx="210">
                  <c:v>XA20220711</c:v>
                </c:pt>
                <c:pt idx="211">
                  <c:v>XA20220712</c:v>
                </c:pt>
                <c:pt idx="212">
                  <c:v>XA20220713</c:v>
                </c:pt>
                <c:pt idx="213">
                  <c:v>XA20220714</c:v>
                </c:pt>
                <c:pt idx="214">
                  <c:v>WHW20220701</c:v>
                </c:pt>
                <c:pt idx="215">
                  <c:v>WHW20220702A</c:v>
                </c:pt>
                <c:pt idx="216">
                  <c:v>WHW20220702B</c:v>
                </c:pt>
                <c:pt idx="217">
                  <c:v>WHW20220702C</c:v>
                </c:pt>
                <c:pt idx="218">
                  <c:v>WHW20220702D</c:v>
                </c:pt>
                <c:pt idx="219">
                  <c:v>WHW20220702E</c:v>
                </c:pt>
                <c:pt idx="220">
                  <c:v>WHW20220702F</c:v>
                </c:pt>
                <c:pt idx="221">
                  <c:v>WHW20220702G</c:v>
                </c:pt>
                <c:pt idx="222">
                  <c:v>WHW20220702H</c:v>
                </c:pt>
                <c:pt idx="223">
                  <c:v>WHW20220703</c:v>
                </c:pt>
                <c:pt idx="224">
                  <c:v>WHW20220704</c:v>
                </c:pt>
                <c:pt idx="225">
                  <c:v>WHW20220705</c:v>
                </c:pt>
                <c:pt idx="226">
                  <c:v>WHW20220706</c:v>
                </c:pt>
                <c:pt idx="227">
                  <c:v>WHW20220707</c:v>
                </c:pt>
                <c:pt idx="228">
                  <c:v>WHW20220708</c:v>
                </c:pt>
                <c:pt idx="229">
                  <c:v>WHW20220709</c:v>
                </c:pt>
                <c:pt idx="230">
                  <c:v>WHW20220710</c:v>
                </c:pt>
                <c:pt idx="231">
                  <c:v>WHW20220711</c:v>
                </c:pt>
                <c:pt idx="232">
                  <c:v>WHW20220712</c:v>
                </c:pt>
                <c:pt idx="233">
                  <c:v>WHW20220713</c:v>
                </c:pt>
                <c:pt idx="234">
                  <c:v>WHW20220714A</c:v>
                </c:pt>
                <c:pt idx="235">
                  <c:v>WHW20220714B</c:v>
                </c:pt>
                <c:pt idx="236">
                  <c:v>WHW20220714C</c:v>
                </c:pt>
                <c:pt idx="237">
                  <c:v>WHW20220714D</c:v>
                </c:pt>
                <c:pt idx="238">
                  <c:v>WHW20220714E</c:v>
                </c:pt>
                <c:pt idx="239">
                  <c:v>WHW20220714F</c:v>
                </c:pt>
                <c:pt idx="240">
                  <c:v>WHW20220714G</c:v>
                </c:pt>
                <c:pt idx="241">
                  <c:v>WHW20220714H</c:v>
                </c:pt>
                <c:pt idx="242">
                  <c:v>WHW20220715</c:v>
                </c:pt>
                <c:pt idx="243">
                  <c:v>WHW20220716</c:v>
                </c:pt>
              </c:strCache>
            </c:strRef>
          </c:cat>
          <c:val>
            <c:numRef>
              <c:f>表型预测结果表!$B$7:$IK$7</c:f>
              <c:numCache>
                <c:formatCode>General</c:formatCode>
                <c:ptCount val="244"/>
                <c:pt idx="0">
                  <c:v>0.50456696907499998</c:v>
                </c:pt>
                <c:pt idx="1">
                  <c:v>0.47975444384600002</c:v>
                </c:pt>
                <c:pt idx="2">
                  <c:v>0.49959326363899997</c:v>
                </c:pt>
                <c:pt idx="3">
                  <c:v>0.42215258138900003</c:v>
                </c:pt>
                <c:pt idx="4">
                  <c:v>0.42002434923800003</c:v>
                </c:pt>
                <c:pt idx="5">
                  <c:v>0.12463267689300001</c:v>
                </c:pt>
                <c:pt idx="6">
                  <c:v>0.72665607293900003</c:v>
                </c:pt>
                <c:pt idx="7">
                  <c:v>0.61509106597300001</c:v>
                </c:pt>
                <c:pt idx="8">
                  <c:v>0.161450851324</c:v>
                </c:pt>
                <c:pt idx="9">
                  <c:v>0.87951207826099997</c:v>
                </c:pt>
                <c:pt idx="10">
                  <c:v>0.70510279761500005</c:v>
                </c:pt>
                <c:pt idx="11">
                  <c:v>0.47234609933299998</c:v>
                </c:pt>
                <c:pt idx="12">
                  <c:v>0.29823383361599998</c:v>
                </c:pt>
                <c:pt idx="13">
                  <c:v>0.80176211453699997</c:v>
                </c:pt>
                <c:pt idx="14">
                  <c:v>0.88471234526099995</c:v>
                </c:pt>
                <c:pt idx="15">
                  <c:v>0.90831946636899996</c:v>
                </c:pt>
                <c:pt idx="16">
                  <c:v>0.63346995404499995</c:v>
                </c:pt>
                <c:pt idx="17">
                  <c:v>0.329313934152</c:v>
                </c:pt>
                <c:pt idx="18">
                  <c:v>0.50289527685000002</c:v>
                </c:pt>
                <c:pt idx="19">
                  <c:v>0.95333848163099999</c:v>
                </c:pt>
                <c:pt idx="20">
                  <c:v>0.96279158137200005</c:v>
                </c:pt>
                <c:pt idx="21">
                  <c:v>0.41509585875400001</c:v>
                </c:pt>
                <c:pt idx="22">
                  <c:v>0.89214708422900002</c:v>
                </c:pt>
                <c:pt idx="23">
                  <c:v>0.99685821228399996</c:v>
                </c:pt>
                <c:pt idx="24">
                  <c:v>0.67829581856300003</c:v>
                </c:pt>
                <c:pt idx="25">
                  <c:v>0.57893098433300005</c:v>
                </c:pt>
                <c:pt idx="26">
                  <c:v>0.60717994435199996</c:v>
                </c:pt>
                <c:pt idx="27">
                  <c:v>0.80329414050299996</c:v>
                </c:pt>
                <c:pt idx="28">
                  <c:v>1</c:v>
                </c:pt>
                <c:pt idx="29">
                  <c:v>0.98608864445199995</c:v>
                </c:pt>
                <c:pt idx="30">
                  <c:v>0.412081485355</c:v>
                </c:pt>
                <c:pt idx="31">
                  <c:v>0.547279462396</c:v>
                </c:pt>
                <c:pt idx="32">
                  <c:v>0.87420463483800004</c:v>
                </c:pt>
                <c:pt idx="33">
                  <c:v>0.97112386636400005</c:v>
                </c:pt>
                <c:pt idx="34">
                  <c:v>0.85351138375900004</c:v>
                </c:pt>
                <c:pt idx="35">
                  <c:v>0.188028895817</c:v>
                </c:pt>
                <c:pt idx="36">
                  <c:v>0.32828233737099999</c:v>
                </c:pt>
                <c:pt idx="37">
                  <c:v>0.63859131646800005</c:v>
                </c:pt>
                <c:pt idx="38">
                  <c:v>0.41537934413799998</c:v>
                </c:pt>
                <c:pt idx="39">
                  <c:v>0.39589353235500002</c:v>
                </c:pt>
                <c:pt idx="40">
                  <c:v>0.54514008080099996</c:v>
                </c:pt>
                <c:pt idx="41">
                  <c:v>5.7227383807200001E-2</c:v>
                </c:pt>
                <c:pt idx="42">
                  <c:v>0.183332585873</c:v>
                </c:pt>
                <c:pt idx="43">
                  <c:v>0.31375551118099998</c:v>
                </c:pt>
                <c:pt idx="44">
                  <c:v>0.51331288495000005</c:v>
                </c:pt>
                <c:pt idx="45">
                  <c:v>0.74614761156099996</c:v>
                </c:pt>
                <c:pt idx="46">
                  <c:v>0.60646951912699998</c:v>
                </c:pt>
                <c:pt idx="47">
                  <c:v>0.39406227605499999</c:v>
                </c:pt>
                <c:pt idx="48">
                  <c:v>9.1275855719199994E-2</c:v>
                </c:pt>
                <c:pt idx="49">
                  <c:v>0.41767923263899998</c:v>
                </c:pt>
                <c:pt idx="50">
                  <c:v>0.66084321672500002</c:v>
                </c:pt>
                <c:pt idx="51">
                  <c:v>0.14158835036699999</c:v>
                </c:pt>
                <c:pt idx="52">
                  <c:v>0.412075832388</c:v>
                </c:pt>
                <c:pt idx="53">
                  <c:v>0.23775260110300001</c:v>
                </c:pt>
                <c:pt idx="54">
                  <c:v>0.10555770861</c:v>
                </c:pt>
                <c:pt idx="55">
                  <c:v>0.63812671742399996</c:v>
                </c:pt>
                <c:pt idx="56">
                  <c:v>0.24170913753500001</c:v>
                </c:pt>
                <c:pt idx="57">
                  <c:v>0.40414111688600002</c:v>
                </c:pt>
                <c:pt idx="58">
                  <c:v>0.41223291893000003</c:v>
                </c:pt>
                <c:pt idx="59">
                  <c:v>0.39926793566899998</c:v>
                </c:pt>
                <c:pt idx="60">
                  <c:v>0.18025885786500001</c:v>
                </c:pt>
                <c:pt idx="61">
                  <c:v>0.37491470837599999</c:v>
                </c:pt>
                <c:pt idx="62">
                  <c:v>0.294616498881</c:v>
                </c:pt>
                <c:pt idx="63">
                  <c:v>0.56302640212199995</c:v>
                </c:pt>
                <c:pt idx="64">
                  <c:v>0.93974068387300003</c:v>
                </c:pt>
                <c:pt idx="65">
                  <c:v>0.77066894914100004</c:v>
                </c:pt>
                <c:pt idx="66">
                  <c:v>0.94888611537900003</c:v>
                </c:pt>
                <c:pt idx="67">
                  <c:v>0.51117737566900001</c:v>
                </c:pt>
                <c:pt idx="68">
                  <c:v>0.20110786375</c:v>
                </c:pt>
                <c:pt idx="69">
                  <c:v>0.33047578809599998</c:v>
                </c:pt>
                <c:pt idx="70">
                  <c:v>0.32656429116500002</c:v>
                </c:pt>
                <c:pt idx="71">
                  <c:v>0.84710236718499998</c:v>
                </c:pt>
                <c:pt idx="72">
                  <c:v>0.16824992574100001</c:v>
                </c:pt>
                <c:pt idx="73">
                  <c:v>0.84919005526400004</c:v>
                </c:pt>
                <c:pt idx="74">
                  <c:v>0.94918835592299999</c:v>
                </c:pt>
                <c:pt idx="75">
                  <c:v>0</c:v>
                </c:pt>
                <c:pt idx="76">
                  <c:v>4.5170970183999997E-3</c:v>
                </c:pt>
                <c:pt idx="77">
                  <c:v>0.96612155755600004</c:v>
                </c:pt>
                <c:pt idx="78">
                  <c:v>0.66269222399500005</c:v>
                </c:pt>
                <c:pt idx="79">
                  <c:v>0.42942008514199997</c:v>
                </c:pt>
                <c:pt idx="80">
                  <c:v>0.20419726067999999</c:v>
                </c:pt>
                <c:pt idx="81">
                  <c:v>0.74040394935800002</c:v>
                </c:pt>
                <c:pt idx="82">
                  <c:v>0.63976465606400001</c:v>
                </c:pt>
                <c:pt idx="83">
                  <c:v>0.85949307304800004</c:v>
                </c:pt>
                <c:pt idx="84">
                  <c:v>6.4194382540700007E-2</c:v>
                </c:pt>
                <c:pt idx="85">
                  <c:v>0.123485414882</c:v>
                </c:pt>
                <c:pt idx="86">
                  <c:v>0.33934590429700001</c:v>
                </c:pt>
                <c:pt idx="87">
                  <c:v>0.78418324945700002</c:v>
                </c:pt>
                <c:pt idx="88">
                  <c:v>0.187880151041</c:v>
                </c:pt>
                <c:pt idx="89">
                  <c:v>0.134895552301</c:v>
                </c:pt>
                <c:pt idx="90">
                  <c:v>0.28244323800900001</c:v>
                </c:pt>
                <c:pt idx="91">
                  <c:v>0.50704650087500003</c:v>
                </c:pt>
                <c:pt idx="92">
                  <c:v>0.62145116519999999</c:v>
                </c:pt>
                <c:pt idx="93">
                  <c:v>0.33307078048200001</c:v>
                </c:pt>
                <c:pt idx="94">
                  <c:v>0.56469443751899995</c:v>
                </c:pt>
                <c:pt idx="95">
                  <c:v>0.14599445465700001</c:v>
                </c:pt>
                <c:pt idx="96">
                  <c:v>4.9227877817399998E-2</c:v>
                </c:pt>
                <c:pt idx="97">
                  <c:v>1.1585838672800001E-2</c:v>
                </c:pt>
                <c:pt idx="98">
                  <c:v>0.172425534188</c:v>
                </c:pt>
                <c:pt idx="99">
                  <c:v>0.71740868143799996</c:v>
                </c:pt>
                <c:pt idx="100">
                  <c:v>0.31529928311400002</c:v>
                </c:pt>
                <c:pt idx="101">
                  <c:v>0.23519901198599999</c:v>
                </c:pt>
                <c:pt idx="102">
                  <c:v>0.16559216847</c:v>
                </c:pt>
                <c:pt idx="103">
                  <c:v>0.89052661705799996</c:v>
                </c:pt>
                <c:pt idx="104">
                  <c:v>9.3359688538500005E-2</c:v>
                </c:pt>
                <c:pt idx="105">
                  <c:v>0.107366417672</c:v>
                </c:pt>
                <c:pt idx="106">
                  <c:v>0.40852496355899998</c:v>
                </c:pt>
                <c:pt idx="107">
                  <c:v>8.8600268715299996E-2</c:v>
                </c:pt>
                <c:pt idx="108">
                  <c:v>1.8252426885099999E-2</c:v>
                </c:pt>
                <c:pt idx="109">
                  <c:v>0.90138494102400002</c:v>
                </c:pt>
                <c:pt idx="110">
                  <c:v>0.93136142975400005</c:v>
                </c:pt>
                <c:pt idx="111">
                  <c:v>0.27880933233100003</c:v>
                </c:pt>
                <c:pt idx="112">
                  <c:v>0.50186498899800003</c:v>
                </c:pt>
                <c:pt idx="113">
                  <c:v>8.0674835977400002E-3</c:v>
                </c:pt>
                <c:pt idx="114">
                  <c:v>0.339807405964</c:v>
                </c:pt>
                <c:pt idx="115">
                  <c:v>5.1346284393100003E-2</c:v>
                </c:pt>
                <c:pt idx="116">
                  <c:v>0.72931000589700001</c:v>
                </c:pt>
                <c:pt idx="117">
                  <c:v>0.472566378909</c:v>
                </c:pt>
                <c:pt idx="118">
                  <c:v>8.2392866751899996E-2</c:v>
                </c:pt>
                <c:pt idx="119">
                  <c:v>0.86852088606800004</c:v>
                </c:pt>
                <c:pt idx="120">
                  <c:v>3.9510224520799997E-2</c:v>
                </c:pt>
                <c:pt idx="121">
                  <c:v>0.216726229769</c:v>
                </c:pt>
                <c:pt idx="122">
                  <c:v>0.69880557739000004</c:v>
                </c:pt>
                <c:pt idx="123">
                  <c:v>0.938873597043</c:v>
                </c:pt>
                <c:pt idx="124">
                  <c:v>0.32388126633999997</c:v>
                </c:pt>
                <c:pt idx="125">
                  <c:v>0.78250778888000005</c:v>
                </c:pt>
                <c:pt idx="126">
                  <c:v>0.55178611211100004</c:v>
                </c:pt>
                <c:pt idx="127">
                  <c:v>0.53546658833000005</c:v>
                </c:pt>
                <c:pt idx="128">
                  <c:v>0.60192352479800004</c:v>
                </c:pt>
                <c:pt idx="129">
                  <c:v>0.71115256134600002</c:v>
                </c:pt>
                <c:pt idx="130">
                  <c:v>0.77827415551199997</c:v>
                </c:pt>
                <c:pt idx="131">
                  <c:v>0.81323991753900005</c:v>
                </c:pt>
                <c:pt idx="132">
                  <c:v>0.95702666443100004</c:v>
                </c:pt>
                <c:pt idx="133">
                  <c:v>0.38845441043099999</c:v>
                </c:pt>
                <c:pt idx="134">
                  <c:v>8.4595552690899995E-4</c:v>
                </c:pt>
                <c:pt idx="135">
                  <c:v>0.88480045507399996</c:v>
                </c:pt>
                <c:pt idx="136">
                  <c:v>0.21572635381899999</c:v>
                </c:pt>
                <c:pt idx="137">
                  <c:v>0.30479251699900001</c:v>
                </c:pt>
                <c:pt idx="138">
                  <c:v>0.64425851125199995</c:v>
                </c:pt>
                <c:pt idx="139">
                  <c:v>0.33375715193900002</c:v>
                </c:pt>
                <c:pt idx="140">
                  <c:v>0.53731882763299998</c:v>
                </c:pt>
                <c:pt idx="141">
                  <c:v>0.50924632661000002</c:v>
                </c:pt>
                <c:pt idx="142">
                  <c:v>0.82884025848999998</c:v>
                </c:pt>
                <c:pt idx="143">
                  <c:v>0.26295377429</c:v>
                </c:pt>
                <c:pt idx="144">
                  <c:v>0.209893350265</c:v>
                </c:pt>
                <c:pt idx="145">
                  <c:v>0.82867214478499995</c:v>
                </c:pt>
                <c:pt idx="146">
                  <c:v>0.29309963843999998</c:v>
                </c:pt>
                <c:pt idx="147">
                  <c:v>0.54854564972700004</c:v>
                </c:pt>
                <c:pt idx="148">
                  <c:v>5.0364809887799997E-2</c:v>
                </c:pt>
                <c:pt idx="149">
                  <c:v>5.6703718192599997E-3</c:v>
                </c:pt>
                <c:pt idx="150">
                  <c:v>0.42765214734700002</c:v>
                </c:pt>
                <c:pt idx="151">
                  <c:v>5.6963341682399998E-2</c:v>
                </c:pt>
                <c:pt idx="152">
                  <c:v>0.19345251413100001</c:v>
                </c:pt>
                <c:pt idx="153">
                  <c:v>5.81581263143E-2</c:v>
                </c:pt>
                <c:pt idx="154">
                  <c:v>4.6825060547400002E-2</c:v>
                </c:pt>
                <c:pt idx="155">
                  <c:v>0.15286771027500001</c:v>
                </c:pt>
                <c:pt idx="156">
                  <c:v>1.31858917772E-2</c:v>
                </c:pt>
                <c:pt idx="157">
                  <c:v>0.95437832352200003</c:v>
                </c:pt>
                <c:pt idx="158">
                  <c:v>0.95112738068799996</c:v>
                </c:pt>
                <c:pt idx="159">
                  <c:v>0.85143848323100002</c:v>
                </c:pt>
                <c:pt idx="160">
                  <c:v>0.79803946068099996</c:v>
                </c:pt>
                <c:pt idx="161">
                  <c:v>0.37061085764099999</c:v>
                </c:pt>
                <c:pt idx="162">
                  <c:v>1.13911859132E-2</c:v>
                </c:pt>
                <c:pt idx="163">
                  <c:v>0.44758909080199999</c:v>
                </c:pt>
                <c:pt idx="164">
                  <c:v>3.8047477876199998E-2</c:v>
                </c:pt>
                <c:pt idx="165">
                  <c:v>0.25022393235599999</c:v>
                </c:pt>
                <c:pt idx="166">
                  <c:v>0.319403919659</c:v>
                </c:pt>
                <c:pt idx="167">
                  <c:v>7.92171327674E-2</c:v>
                </c:pt>
                <c:pt idx="168">
                  <c:v>0.44087464606999999</c:v>
                </c:pt>
                <c:pt idx="169">
                  <c:v>0.41358822969699999</c:v>
                </c:pt>
                <c:pt idx="170">
                  <c:v>0.52765799096699995</c:v>
                </c:pt>
                <c:pt idx="171">
                  <c:v>4.4902304816900003E-2</c:v>
                </c:pt>
                <c:pt idx="172">
                  <c:v>1.0951746440499999E-2</c:v>
                </c:pt>
                <c:pt idx="173">
                  <c:v>7.4270329118800004E-3</c:v>
                </c:pt>
                <c:pt idx="174">
                  <c:v>0.27372430704</c:v>
                </c:pt>
                <c:pt idx="175">
                  <c:v>2.5442385340900001E-2</c:v>
                </c:pt>
                <c:pt idx="176">
                  <c:v>0.35300877713599998</c:v>
                </c:pt>
                <c:pt idx="177">
                  <c:v>2.2283651034500002E-2</c:v>
                </c:pt>
                <c:pt idx="178">
                  <c:v>9.9634544054099994E-2</c:v>
                </c:pt>
                <c:pt idx="179">
                  <c:v>0.607895875842</c:v>
                </c:pt>
                <c:pt idx="180">
                  <c:v>0.15366430522800001</c:v>
                </c:pt>
                <c:pt idx="181">
                  <c:v>0.317926599102</c:v>
                </c:pt>
                <c:pt idx="182">
                  <c:v>4.5670790442499998E-2</c:v>
                </c:pt>
                <c:pt idx="183">
                  <c:v>7.8889375575400003E-2</c:v>
                </c:pt>
                <c:pt idx="184">
                  <c:v>0.19983663169800001</c:v>
                </c:pt>
                <c:pt idx="185">
                  <c:v>2.1960387020399999E-2</c:v>
                </c:pt>
                <c:pt idx="186">
                  <c:v>0.10237941178899999</c:v>
                </c:pt>
                <c:pt idx="187">
                  <c:v>0</c:v>
                </c:pt>
                <c:pt idx="188">
                  <c:v>0.34371742863400001</c:v>
                </c:pt>
                <c:pt idx="189">
                  <c:v>0.19982442459399999</c:v>
                </c:pt>
                <c:pt idx="190">
                  <c:v>0.102428842563</c:v>
                </c:pt>
                <c:pt idx="191">
                  <c:v>0.80604382027300003</c:v>
                </c:pt>
                <c:pt idx="192">
                  <c:v>0.31876575167100002</c:v>
                </c:pt>
                <c:pt idx="193">
                  <c:v>0.104063947904</c:v>
                </c:pt>
                <c:pt idx="194">
                  <c:v>6.39680873082E-2</c:v>
                </c:pt>
                <c:pt idx="195">
                  <c:v>0.60847298839399999</c:v>
                </c:pt>
                <c:pt idx="196">
                  <c:v>0.28957799666299999</c:v>
                </c:pt>
                <c:pt idx="197">
                  <c:v>0.29362477576500001</c:v>
                </c:pt>
                <c:pt idx="198">
                  <c:v>0.85761958376400005</c:v>
                </c:pt>
                <c:pt idx="199">
                  <c:v>0.19822629574100001</c:v>
                </c:pt>
                <c:pt idx="200">
                  <c:v>0.17035428968399999</c:v>
                </c:pt>
                <c:pt idx="201">
                  <c:v>0.139241300205</c:v>
                </c:pt>
                <c:pt idx="202">
                  <c:v>9.9703114727200004E-2</c:v>
                </c:pt>
                <c:pt idx="203">
                  <c:v>0.108237938748</c:v>
                </c:pt>
                <c:pt idx="204">
                  <c:v>1.54037449997E-2</c:v>
                </c:pt>
                <c:pt idx="205">
                  <c:v>0.17596648182800001</c:v>
                </c:pt>
                <c:pt idx="206">
                  <c:v>6.1773185903699998E-2</c:v>
                </c:pt>
                <c:pt idx="207">
                  <c:v>9.47089505241E-2</c:v>
                </c:pt>
                <c:pt idx="208">
                  <c:v>0.12272604470700001</c:v>
                </c:pt>
                <c:pt idx="209">
                  <c:v>0.18858467471000001</c:v>
                </c:pt>
                <c:pt idx="210">
                  <c:v>8.5625218814200002E-2</c:v>
                </c:pt>
                <c:pt idx="211">
                  <c:v>0.20573148773300001</c:v>
                </c:pt>
                <c:pt idx="212">
                  <c:v>0.248258857842</c:v>
                </c:pt>
                <c:pt idx="213">
                  <c:v>0.12992751780299999</c:v>
                </c:pt>
                <c:pt idx="214">
                  <c:v>0.159635425862</c:v>
                </c:pt>
                <c:pt idx="215">
                  <c:v>0.31850508978199998</c:v>
                </c:pt>
                <c:pt idx="216">
                  <c:v>0.248912624538</c:v>
                </c:pt>
                <c:pt idx="217">
                  <c:v>0.191812495177</c:v>
                </c:pt>
                <c:pt idx="218">
                  <c:v>0.234163850471</c:v>
                </c:pt>
                <c:pt idx="219">
                  <c:v>0.19031535883699999</c:v>
                </c:pt>
                <c:pt idx="220">
                  <c:v>0.209419233939</c:v>
                </c:pt>
                <c:pt idx="221">
                  <c:v>0.24257373068499999</c:v>
                </c:pt>
                <c:pt idx="222">
                  <c:v>0.429884296587</c:v>
                </c:pt>
                <c:pt idx="223">
                  <c:v>0.211166512926</c:v>
                </c:pt>
                <c:pt idx="224">
                  <c:v>0.211154918266</c:v>
                </c:pt>
                <c:pt idx="225">
                  <c:v>0.182457291129</c:v>
                </c:pt>
                <c:pt idx="226">
                  <c:v>0.20874765914000001</c:v>
                </c:pt>
                <c:pt idx="227">
                  <c:v>0.18550124631100001</c:v>
                </c:pt>
                <c:pt idx="228">
                  <c:v>0.196584297598</c:v>
                </c:pt>
                <c:pt idx="229">
                  <c:v>0.18724842518900001</c:v>
                </c:pt>
                <c:pt idx="230">
                  <c:v>0.174754446546</c:v>
                </c:pt>
                <c:pt idx="231">
                  <c:v>0.18264238700400001</c:v>
                </c:pt>
                <c:pt idx="232">
                  <c:v>0.17131396200499999</c:v>
                </c:pt>
                <c:pt idx="233">
                  <c:v>0.16679156002100001</c:v>
                </c:pt>
                <c:pt idx="234">
                  <c:v>0.21874193056300001</c:v>
                </c:pt>
                <c:pt idx="235">
                  <c:v>0.171002987115</c:v>
                </c:pt>
                <c:pt idx="236">
                  <c:v>0.142722530249</c:v>
                </c:pt>
                <c:pt idx="237">
                  <c:v>0.133759473362</c:v>
                </c:pt>
                <c:pt idx="238">
                  <c:v>0.14699668708999999</c:v>
                </c:pt>
                <c:pt idx="239">
                  <c:v>0.14876888927000001</c:v>
                </c:pt>
                <c:pt idx="240">
                  <c:v>0.149451082905</c:v>
                </c:pt>
                <c:pt idx="241">
                  <c:v>0.174143034211</c:v>
                </c:pt>
                <c:pt idx="242">
                  <c:v>0.16297535467300001</c:v>
                </c:pt>
                <c:pt idx="243">
                  <c:v>0.1259566873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2384"/>
        <c:axId val="1474944"/>
      </c:barChart>
      <c:catAx>
        <c:axId val="14723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Samples</a:t>
                </a:r>
                <a:endParaRPr lang="zh-CN" altLang="en-US" sz="1200"/>
              </a:p>
            </c:rich>
          </c:tx>
          <c:layout>
            <c:manualLayout>
              <c:xMode val="edge"/>
              <c:yMode val="edge"/>
              <c:x val="0.49752529539755486"/>
              <c:y val="0.91571741032370957"/>
            </c:manualLayout>
          </c:layout>
          <c:overlay val="0"/>
        </c:title>
        <c:majorTickMark val="none"/>
        <c:minorTickMark val="none"/>
        <c:tickLblPos val="nextTo"/>
        <c:crossAx val="1474944"/>
        <c:crosses val="autoZero"/>
        <c:auto val="1"/>
        <c:lblAlgn val="ctr"/>
        <c:lblOffset val="100"/>
        <c:noMultiLvlLbl val="0"/>
      </c:catAx>
      <c:valAx>
        <c:axId val="1474944"/>
        <c:scaling>
          <c:orientation val="minMax"/>
          <c:max val="1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Percent</a:t>
                </a:r>
                <a:endParaRPr lang="zh-CN" altLang="en-US" sz="12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72384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600" b="1" i="0" u="none" strike="noStrike" baseline="0">
                <a:effectLst/>
              </a:rPr>
              <a:t>Percent of the microbes with the phenotype of </a:t>
            </a:r>
            <a:r>
              <a:rPr lang="en-US" altLang="en-US" sz="1600"/>
              <a:t>Contains Mobile Elements </a:t>
            </a:r>
            <a:r>
              <a:rPr lang="en-US" altLang="zh-CN" sz="1600" b="1" i="0" baseline="0">
                <a:effectLst/>
              </a:rPr>
              <a:t>in each sample</a:t>
            </a:r>
            <a:endParaRPr lang="zh-CN" altLang="zh-CN" sz="1600">
              <a:effectLst/>
            </a:endParaRP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5.189520936051218E-2"/>
          <c:y val="0.19480351414406533"/>
          <c:w val="0.93439762553045358"/>
          <c:h val="0.361021799358413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表型预测结果表!$A$10</c:f>
              <c:strCache>
                <c:ptCount val="1"/>
                <c:pt idx="0">
                  <c:v>Contains_Mobile_Elements</c:v>
                </c:pt>
              </c:strCache>
            </c:strRef>
          </c:tx>
          <c:invertIfNegative val="0"/>
          <c:cat>
            <c:strRef>
              <c:f>表型预测结果表!$B$9:$IK$9</c:f>
              <c:strCache>
                <c:ptCount val="244"/>
                <c:pt idx="0">
                  <c:v>AN20220701</c:v>
                </c:pt>
                <c:pt idx="1">
                  <c:v>AN20220702</c:v>
                </c:pt>
                <c:pt idx="2">
                  <c:v>AN20220703</c:v>
                </c:pt>
                <c:pt idx="3">
                  <c:v>AN20220704</c:v>
                </c:pt>
                <c:pt idx="4">
                  <c:v>AN20220705</c:v>
                </c:pt>
                <c:pt idx="5">
                  <c:v>CB20220701</c:v>
                </c:pt>
                <c:pt idx="6">
                  <c:v>CB20220702</c:v>
                </c:pt>
                <c:pt idx="7">
                  <c:v>CB20220703</c:v>
                </c:pt>
                <c:pt idx="8">
                  <c:v>CB20220704</c:v>
                </c:pt>
                <c:pt idx="9">
                  <c:v>CB20220705</c:v>
                </c:pt>
                <c:pt idx="10">
                  <c:v>CB20220706</c:v>
                </c:pt>
                <c:pt idx="11">
                  <c:v>CB20220707</c:v>
                </c:pt>
                <c:pt idx="12">
                  <c:v>CB20220708</c:v>
                </c:pt>
                <c:pt idx="13">
                  <c:v>CB20220709</c:v>
                </c:pt>
                <c:pt idx="14">
                  <c:v>CB20220710</c:v>
                </c:pt>
                <c:pt idx="15">
                  <c:v>CB20220711</c:v>
                </c:pt>
                <c:pt idx="16">
                  <c:v>CB20220712</c:v>
                </c:pt>
                <c:pt idx="17">
                  <c:v>CB20220713</c:v>
                </c:pt>
                <c:pt idx="18">
                  <c:v>CB20220714</c:v>
                </c:pt>
                <c:pt idx="19">
                  <c:v>CB20220715</c:v>
                </c:pt>
                <c:pt idx="20">
                  <c:v>CB20220716</c:v>
                </c:pt>
                <c:pt idx="21">
                  <c:v>CB20220717</c:v>
                </c:pt>
                <c:pt idx="22">
                  <c:v>CB20220718</c:v>
                </c:pt>
                <c:pt idx="23">
                  <c:v>CB20220719</c:v>
                </c:pt>
                <c:pt idx="24">
                  <c:v>CB20220720</c:v>
                </c:pt>
                <c:pt idx="25">
                  <c:v>CB20220721</c:v>
                </c:pt>
                <c:pt idx="26">
                  <c:v>CB20220722</c:v>
                </c:pt>
                <c:pt idx="27">
                  <c:v>CB20220723</c:v>
                </c:pt>
                <c:pt idx="28">
                  <c:v>CB20220724</c:v>
                </c:pt>
                <c:pt idx="29">
                  <c:v>CB20220725</c:v>
                </c:pt>
                <c:pt idx="30">
                  <c:v>CB20220726</c:v>
                </c:pt>
                <c:pt idx="31">
                  <c:v>CB20220727</c:v>
                </c:pt>
                <c:pt idx="32">
                  <c:v>CB20220728</c:v>
                </c:pt>
                <c:pt idx="33">
                  <c:v>CB20220729</c:v>
                </c:pt>
                <c:pt idx="34">
                  <c:v>CB20220730</c:v>
                </c:pt>
                <c:pt idx="35">
                  <c:v>CB20220731</c:v>
                </c:pt>
                <c:pt idx="36">
                  <c:v>CH20220701</c:v>
                </c:pt>
                <c:pt idx="37">
                  <c:v>CH20220702</c:v>
                </c:pt>
                <c:pt idx="38">
                  <c:v>CH20220703</c:v>
                </c:pt>
                <c:pt idx="39">
                  <c:v>CH20220704</c:v>
                </c:pt>
                <c:pt idx="40">
                  <c:v>CH20220705</c:v>
                </c:pt>
                <c:pt idx="41">
                  <c:v>CH20220706</c:v>
                </c:pt>
                <c:pt idx="42">
                  <c:v>CH20220707</c:v>
                </c:pt>
                <c:pt idx="43">
                  <c:v>CH20220708</c:v>
                </c:pt>
                <c:pt idx="44">
                  <c:v>CH20220709</c:v>
                </c:pt>
                <c:pt idx="45">
                  <c:v>CH20220710</c:v>
                </c:pt>
                <c:pt idx="46">
                  <c:v>CH20220711</c:v>
                </c:pt>
                <c:pt idx="47">
                  <c:v>CH20220712</c:v>
                </c:pt>
                <c:pt idx="48">
                  <c:v>CH20220713</c:v>
                </c:pt>
                <c:pt idx="49">
                  <c:v>CH20220714</c:v>
                </c:pt>
                <c:pt idx="50">
                  <c:v>CH20220715</c:v>
                </c:pt>
                <c:pt idx="51">
                  <c:v>CH20220716</c:v>
                </c:pt>
                <c:pt idx="52">
                  <c:v>CH20220717</c:v>
                </c:pt>
                <c:pt idx="53">
                  <c:v>CH20220718</c:v>
                </c:pt>
                <c:pt idx="54">
                  <c:v>CH20220719</c:v>
                </c:pt>
                <c:pt idx="55">
                  <c:v>CH20220720</c:v>
                </c:pt>
                <c:pt idx="56">
                  <c:v>CH20220721</c:v>
                </c:pt>
                <c:pt idx="57">
                  <c:v>CH20220722</c:v>
                </c:pt>
                <c:pt idx="58">
                  <c:v>CH20220723</c:v>
                </c:pt>
                <c:pt idx="59">
                  <c:v>CH20220724</c:v>
                </c:pt>
                <c:pt idx="60">
                  <c:v>CH20220725</c:v>
                </c:pt>
                <c:pt idx="61">
                  <c:v>CH20220726</c:v>
                </c:pt>
                <c:pt idx="62">
                  <c:v>CH20220727</c:v>
                </c:pt>
                <c:pt idx="63">
                  <c:v>CH20220728</c:v>
                </c:pt>
                <c:pt idx="64">
                  <c:v>CH20220729</c:v>
                </c:pt>
                <c:pt idx="65">
                  <c:v>CH20220730</c:v>
                </c:pt>
                <c:pt idx="66">
                  <c:v>CH20220731</c:v>
                </c:pt>
                <c:pt idx="67">
                  <c:v>CH20220732</c:v>
                </c:pt>
                <c:pt idx="68">
                  <c:v>CH20220733</c:v>
                </c:pt>
                <c:pt idx="69">
                  <c:v>CH20220734</c:v>
                </c:pt>
                <c:pt idx="70">
                  <c:v>CH20220735</c:v>
                </c:pt>
                <c:pt idx="71">
                  <c:v>HM20220701</c:v>
                </c:pt>
                <c:pt idx="72">
                  <c:v>HM20220702</c:v>
                </c:pt>
                <c:pt idx="73">
                  <c:v>HM20220703</c:v>
                </c:pt>
                <c:pt idx="74">
                  <c:v>HM20220704</c:v>
                </c:pt>
                <c:pt idx="75">
                  <c:v>LC20220701</c:v>
                </c:pt>
                <c:pt idx="76">
                  <c:v>LC20220702</c:v>
                </c:pt>
                <c:pt idx="77">
                  <c:v>LC20220703</c:v>
                </c:pt>
                <c:pt idx="78">
                  <c:v>LC20220704</c:v>
                </c:pt>
                <c:pt idx="79">
                  <c:v>LC20220705</c:v>
                </c:pt>
                <c:pt idx="80">
                  <c:v>LC20220706</c:v>
                </c:pt>
                <c:pt idx="81">
                  <c:v>LC20220707</c:v>
                </c:pt>
                <c:pt idx="82">
                  <c:v>LC20220708</c:v>
                </c:pt>
                <c:pt idx="83">
                  <c:v>LC20220709</c:v>
                </c:pt>
                <c:pt idx="84">
                  <c:v>LC20220710</c:v>
                </c:pt>
                <c:pt idx="85">
                  <c:v>LC20220711</c:v>
                </c:pt>
                <c:pt idx="86">
                  <c:v>LC20220712</c:v>
                </c:pt>
                <c:pt idx="87">
                  <c:v>LC20220713</c:v>
                </c:pt>
                <c:pt idx="88">
                  <c:v>LC20220714</c:v>
                </c:pt>
                <c:pt idx="89">
                  <c:v>LC20220715</c:v>
                </c:pt>
                <c:pt idx="90">
                  <c:v>LC20220716</c:v>
                </c:pt>
                <c:pt idx="91">
                  <c:v>LC20220717</c:v>
                </c:pt>
                <c:pt idx="92">
                  <c:v>LC20220718</c:v>
                </c:pt>
                <c:pt idx="93">
                  <c:v>LC20220719</c:v>
                </c:pt>
                <c:pt idx="94">
                  <c:v>LC20220720</c:v>
                </c:pt>
                <c:pt idx="95">
                  <c:v>LC20220721</c:v>
                </c:pt>
                <c:pt idx="96">
                  <c:v>LC20220722</c:v>
                </c:pt>
                <c:pt idx="97">
                  <c:v>LC20220723</c:v>
                </c:pt>
                <c:pt idx="98">
                  <c:v>LC20220724</c:v>
                </c:pt>
                <c:pt idx="99">
                  <c:v>LC20220725</c:v>
                </c:pt>
                <c:pt idx="100">
                  <c:v>LC20220726</c:v>
                </c:pt>
                <c:pt idx="101">
                  <c:v>LC20220727</c:v>
                </c:pt>
                <c:pt idx="102">
                  <c:v>LC20220728</c:v>
                </c:pt>
                <c:pt idx="103">
                  <c:v>LC20220729</c:v>
                </c:pt>
                <c:pt idx="104">
                  <c:v>LC20220730</c:v>
                </c:pt>
                <c:pt idx="105">
                  <c:v>LC20220731</c:v>
                </c:pt>
                <c:pt idx="106">
                  <c:v>LL20220701</c:v>
                </c:pt>
                <c:pt idx="107">
                  <c:v>LL20220702</c:v>
                </c:pt>
                <c:pt idx="108">
                  <c:v>LL20220703</c:v>
                </c:pt>
                <c:pt idx="109">
                  <c:v>LL20220704</c:v>
                </c:pt>
                <c:pt idx="110">
                  <c:v>LL20220705</c:v>
                </c:pt>
                <c:pt idx="111">
                  <c:v>LL20220706</c:v>
                </c:pt>
                <c:pt idx="112">
                  <c:v>LL20220707</c:v>
                </c:pt>
                <c:pt idx="113">
                  <c:v>LL20220708</c:v>
                </c:pt>
                <c:pt idx="114">
                  <c:v>LL20220709</c:v>
                </c:pt>
                <c:pt idx="115">
                  <c:v>LL20220710</c:v>
                </c:pt>
                <c:pt idx="116">
                  <c:v>LL20220711</c:v>
                </c:pt>
                <c:pt idx="117">
                  <c:v>LL20220712</c:v>
                </c:pt>
                <c:pt idx="118">
                  <c:v>LL20220713</c:v>
                </c:pt>
                <c:pt idx="119">
                  <c:v>LL20220714</c:v>
                </c:pt>
                <c:pt idx="120">
                  <c:v>LL20220715</c:v>
                </c:pt>
                <c:pt idx="121">
                  <c:v>LL20220716</c:v>
                </c:pt>
                <c:pt idx="122">
                  <c:v>LL20220717</c:v>
                </c:pt>
                <c:pt idx="123">
                  <c:v>LL20220718</c:v>
                </c:pt>
                <c:pt idx="124">
                  <c:v>LL20220719</c:v>
                </c:pt>
                <c:pt idx="125">
                  <c:v>LL20220720</c:v>
                </c:pt>
                <c:pt idx="126">
                  <c:v>LL20220721</c:v>
                </c:pt>
                <c:pt idx="127">
                  <c:v>LL20220722</c:v>
                </c:pt>
                <c:pt idx="128">
                  <c:v>LL20220723</c:v>
                </c:pt>
                <c:pt idx="129">
                  <c:v>LL20220724</c:v>
                </c:pt>
                <c:pt idx="130">
                  <c:v>LL20220725</c:v>
                </c:pt>
                <c:pt idx="131">
                  <c:v>LL20220726</c:v>
                </c:pt>
                <c:pt idx="132">
                  <c:v>LL20220727</c:v>
                </c:pt>
                <c:pt idx="133">
                  <c:v>LL20220728</c:v>
                </c:pt>
                <c:pt idx="134">
                  <c:v>LL20220729</c:v>
                </c:pt>
                <c:pt idx="135">
                  <c:v>LL20220730</c:v>
                </c:pt>
                <c:pt idx="136">
                  <c:v>LL20220731</c:v>
                </c:pt>
                <c:pt idx="137">
                  <c:v>LL20220732</c:v>
                </c:pt>
                <c:pt idx="138">
                  <c:v>LL20220733</c:v>
                </c:pt>
                <c:pt idx="139">
                  <c:v>LL20220734</c:v>
                </c:pt>
                <c:pt idx="140">
                  <c:v>LL20220735</c:v>
                </c:pt>
                <c:pt idx="141">
                  <c:v>LL20220736</c:v>
                </c:pt>
                <c:pt idx="142">
                  <c:v>LL20220737</c:v>
                </c:pt>
                <c:pt idx="143">
                  <c:v>LL20220738</c:v>
                </c:pt>
                <c:pt idx="144">
                  <c:v>LL20220739</c:v>
                </c:pt>
                <c:pt idx="145">
                  <c:v>LL20220740</c:v>
                </c:pt>
                <c:pt idx="146">
                  <c:v>LL20220741</c:v>
                </c:pt>
                <c:pt idx="147">
                  <c:v>PF20220701</c:v>
                </c:pt>
                <c:pt idx="148">
                  <c:v>PF20220702</c:v>
                </c:pt>
                <c:pt idx="149">
                  <c:v>PF20220703</c:v>
                </c:pt>
                <c:pt idx="150">
                  <c:v>PF20220704</c:v>
                </c:pt>
                <c:pt idx="151">
                  <c:v>PF20220705</c:v>
                </c:pt>
                <c:pt idx="152">
                  <c:v>PF20220706</c:v>
                </c:pt>
                <c:pt idx="153">
                  <c:v>PF20220707</c:v>
                </c:pt>
                <c:pt idx="154">
                  <c:v>PF20220708</c:v>
                </c:pt>
                <c:pt idx="155">
                  <c:v>PF20220709</c:v>
                </c:pt>
                <c:pt idx="156">
                  <c:v>PF20220710</c:v>
                </c:pt>
                <c:pt idx="157">
                  <c:v>PF20220711</c:v>
                </c:pt>
                <c:pt idx="158">
                  <c:v>PF20220712</c:v>
                </c:pt>
                <c:pt idx="159">
                  <c:v>PF20220713</c:v>
                </c:pt>
                <c:pt idx="160">
                  <c:v>PF20220714</c:v>
                </c:pt>
                <c:pt idx="161">
                  <c:v>PF20220715</c:v>
                </c:pt>
                <c:pt idx="162">
                  <c:v>PF20220716</c:v>
                </c:pt>
                <c:pt idx="163">
                  <c:v>PN20220701</c:v>
                </c:pt>
                <c:pt idx="164">
                  <c:v>PN20220702</c:v>
                </c:pt>
                <c:pt idx="165">
                  <c:v>PN20220703</c:v>
                </c:pt>
                <c:pt idx="166">
                  <c:v>PN20220704</c:v>
                </c:pt>
                <c:pt idx="167">
                  <c:v>PN20220705</c:v>
                </c:pt>
                <c:pt idx="168">
                  <c:v>PN20220706</c:v>
                </c:pt>
                <c:pt idx="169">
                  <c:v>PN20220707</c:v>
                </c:pt>
                <c:pt idx="170">
                  <c:v>PN20220708</c:v>
                </c:pt>
                <c:pt idx="171">
                  <c:v>PN20220709</c:v>
                </c:pt>
                <c:pt idx="172">
                  <c:v>PN20220710</c:v>
                </c:pt>
                <c:pt idx="173">
                  <c:v>PN20220711</c:v>
                </c:pt>
                <c:pt idx="174">
                  <c:v>PT20220701</c:v>
                </c:pt>
                <c:pt idx="175">
                  <c:v>PT20220702</c:v>
                </c:pt>
                <c:pt idx="176">
                  <c:v>PT20220703</c:v>
                </c:pt>
                <c:pt idx="177">
                  <c:v>PT20220704</c:v>
                </c:pt>
                <c:pt idx="178">
                  <c:v>PT20220705</c:v>
                </c:pt>
                <c:pt idx="179">
                  <c:v>PT20220706</c:v>
                </c:pt>
                <c:pt idx="180">
                  <c:v>PV20220701</c:v>
                </c:pt>
                <c:pt idx="181">
                  <c:v>PV20220702</c:v>
                </c:pt>
                <c:pt idx="182">
                  <c:v>PV20220703</c:v>
                </c:pt>
                <c:pt idx="183">
                  <c:v>PV20220704</c:v>
                </c:pt>
                <c:pt idx="184">
                  <c:v>SC20220701</c:v>
                </c:pt>
                <c:pt idx="185">
                  <c:v>SC20220702</c:v>
                </c:pt>
                <c:pt idx="186">
                  <c:v>SC20220703</c:v>
                </c:pt>
                <c:pt idx="187">
                  <c:v>SC20220704</c:v>
                </c:pt>
                <c:pt idx="188">
                  <c:v>SC20220705</c:v>
                </c:pt>
                <c:pt idx="189">
                  <c:v>SC20220706</c:v>
                </c:pt>
                <c:pt idx="190">
                  <c:v>SC20220707</c:v>
                </c:pt>
                <c:pt idx="191">
                  <c:v>SC20220708</c:v>
                </c:pt>
                <c:pt idx="192">
                  <c:v>SC20220709</c:v>
                </c:pt>
                <c:pt idx="193">
                  <c:v>SK20220701</c:v>
                </c:pt>
                <c:pt idx="194">
                  <c:v>SK20220702</c:v>
                </c:pt>
                <c:pt idx="195">
                  <c:v>SK20220703</c:v>
                </c:pt>
                <c:pt idx="196">
                  <c:v>SK20220704</c:v>
                </c:pt>
                <c:pt idx="197">
                  <c:v>SK20220705</c:v>
                </c:pt>
                <c:pt idx="198">
                  <c:v>SM20220701</c:v>
                </c:pt>
                <c:pt idx="199">
                  <c:v>SM20220702</c:v>
                </c:pt>
                <c:pt idx="200">
                  <c:v>XA20220701</c:v>
                </c:pt>
                <c:pt idx="201">
                  <c:v>XA20220702</c:v>
                </c:pt>
                <c:pt idx="202">
                  <c:v>XA20220703</c:v>
                </c:pt>
                <c:pt idx="203">
                  <c:v>XA20220704</c:v>
                </c:pt>
                <c:pt idx="204">
                  <c:v>XA20220705</c:v>
                </c:pt>
                <c:pt idx="205">
                  <c:v>XA20220706</c:v>
                </c:pt>
                <c:pt idx="206">
                  <c:v>XA20220707</c:v>
                </c:pt>
                <c:pt idx="207">
                  <c:v>XA20220708</c:v>
                </c:pt>
                <c:pt idx="208">
                  <c:v>XA20220709</c:v>
                </c:pt>
                <c:pt idx="209">
                  <c:v>XA20220710</c:v>
                </c:pt>
                <c:pt idx="210">
                  <c:v>XA20220711</c:v>
                </c:pt>
                <c:pt idx="211">
                  <c:v>XA20220712</c:v>
                </c:pt>
                <c:pt idx="212">
                  <c:v>XA20220713</c:v>
                </c:pt>
                <c:pt idx="213">
                  <c:v>XA20220714</c:v>
                </c:pt>
                <c:pt idx="214">
                  <c:v>WHW20220701</c:v>
                </c:pt>
                <c:pt idx="215">
                  <c:v>WHW20220702A</c:v>
                </c:pt>
                <c:pt idx="216">
                  <c:v>WHW20220702B</c:v>
                </c:pt>
                <c:pt idx="217">
                  <c:v>WHW20220702C</c:v>
                </c:pt>
                <c:pt idx="218">
                  <c:v>WHW20220702D</c:v>
                </c:pt>
                <c:pt idx="219">
                  <c:v>WHW20220702E</c:v>
                </c:pt>
                <c:pt idx="220">
                  <c:v>WHW20220702F</c:v>
                </c:pt>
                <c:pt idx="221">
                  <c:v>WHW20220702G</c:v>
                </c:pt>
                <c:pt idx="222">
                  <c:v>WHW20220702H</c:v>
                </c:pt>
                <c:pt idx="223">
                  <c:v>WHW20220703</c:v>
                </c:pt>
                <c:pt idx="224">
                  <c:v>WHW20220704</c:v>
                </c:pt>
                <c:pt idx="225">
                  <c:v>WHW20220705</c:v>
                </c:pt>
                <c:pt idx="226">
                  <c:v>WHW20220706</c:v>
                </c:pt>
                <c:pt idx="227">
                  <c:v>WHW20220707</c:v>
                </c:pt>
                <c:pt idx="228">
                  <c:v>WHW20220708</c:v>
                </c:pt>
                <c:pt idx="229">
                  <c:v>WHW20220709</c:v>
                </c:pt>
                <c:pt idx="230">
                  <c:v>WHW20220710</c:v>
                </c:pt>
                <c:pt idx="231">
                  <c:v>WHW20220711</c:v>
                </c:pt>
                <c:pt idx="232">
                  <c:v>WHW20220712</c:v>
                </c:pt>
                <c:pt idx="233">
                  <c:v>WHW20220713</c:v>
                </c:pt>
                <c:pt idx="234">
                  <c:v>WHW20220714A</c:v>
                </c:pt>
                <c:pt idx="235">
                  <c:v>WHW20220714B</c:v>
                </c:pt>
                <c:pt idx="236">
                  <c:v>WHW20220714C</c:v>
                </c:pt>
                <c:pt idx="237">
                  <c:v>WHW20220714D</c:v>
                </c:pt>
                <c:pt idx="238">
                  <c:v>WHW20220714E</c:v>
                </c:pt>
                <c:pt idx="239">
                  <c:v>WHW20220714F</c:v>
                </c:pt>
                <c:pt idx="240">
                  <c:v>WHW20220714G</c:v>
                </c:pt>
                <c:pt idx="241">
                  <c:v>WHW20220714H</c:v>
                </c:pt>
                <c:pt idx="242">
                  <c:v>WHW20220715</c:v>
                </c:pt>
                <c:pt idx="243">
                  <c:v>WHW20220716</c:v>
                </c:pt>
              </c:strCache>
            </c:strRef>
          </c:cat>
          <c:val>
            <c:numRef>
              <c:f>表型预测结果表!$B$10:$IK$10</c:f>
              <c:numCache>
                <c:formatCode>General</c:formatCode>
                <c:ptCount val="244"/>
                <c:pt idx="0">
                  <c:v>0.41366286343000003</c:v>
                </c:pt>
                <c:pt idx="1">
                  <c:v>0.24319638647299999</c:v>
                </c:pt>
                <c:pt idx="2">
                  <c:v>0.51720769655099996</c:v>
                </c:pt>
                <c:pt idx="3">
                  <c:v>0.40329144688700003</c:v>
                </c:pt>
                <c:pt idx="4">
                  <c:v>0.71946199779700004</c:v>
                </c:pt>
                <c:pt idx="5">
                  <c:v>1.00073955096E-2</c:v>
                </c:pt>
                <c:pt idx="6">
                  <c:v>7.2644991737499998E-2</c:v>
                </c:pt>
                <c:pt idx="7">
                  <c:v>0.59205428977899999</c:v>
                </c:pt>
                <c:pt idx="8">
                  <c:v>0.237689728997</c:v>
                </c:pt>
                <c:pt idx="9">
                  <c:v>0.891830770868</c:v>
                </c:pt>
                <c:pt idx="10">
                  <c:v>0.60357543975100003</c:v>
                </c:pt>
                <c:pt idx="11">
                  <c:v>0.21777262430300001</c:v>
                </c:pt>
                <c:pt idx="12">
                  <c:v>0.15687828781400001</c:v>
                </c:pt>
                <c:pt idx="13">
                  <c:v>0.479823788546</c:v>
                </c:pt>
                <c:pt idx="14">
                  <c:v>0.84928697746199999</c:v>
                </c:pt>
                <c:pt idx="15">
                  <c:v>0.97587469555899997</c:v>
                </c:pt>
                <c:pt idx="16">
                  <c:v>0.62616856666800003</c:v>
                </c:pt>
                <c:pt idx="17">
                  <c:v>0.58357330602900004</c:v>
                </c:pt>
                <c:pt idx="18">
                  <c:v>0.40095700281199997</c:v>
                </c:pt>
                <c:pt idx="19">
                  <c:v>0.96194852831800004</c:v>
                </c:pt>
                <c:pt idx="20">
                  <c:v>0.91508191620400003</c:v>
                </c:pt>
                <c:pt idx="21">
                  <c:v>0.53587968811999998</c:v>
                </c:pt>
                <c:pt idx="22">
                  <c:v>0.10973311499000001</c:v>
                </c:pt>
                <c:pt idx="23">
                  <c:v>0.95938948470800001</c:v>
                </c:pt>
                <c:pt idx="24">
                  <c:v>0.291436567408</c:v>
                </c:pt>
                <c:pt idx="25">
                  <c:v>7.1841666220800002E-2</c:v>
                </c:pt>
                <c:pt idx="26">
                  <c:v>0.28454637336400002</c:v>
                </c:pt>
                <c:pt idx="27">
                  <c:v>8.8174908158799997E-2</c:v>
                </c:pt>
                <c:pt idx="28">
                  <c:v>0.99681631260799997</c:v>
                </c:pt>
                <c:pt idx="29">
                  <c:v>3.5587188612099998E-3</c:v>
                </c:pt>
                <c:pt idx="30">
                  <c:v>0.42061952036</c:v>
                </c:pt>
                <c:pt idx="31">
                  <c:v>0.53561606862</c:v>
                </c:pt>
                <c:pt idx="32">
                  <c:v>0.123039165082</c:v>
                </c:pt>
                <c:pt idx="33">
                  <c:v>1.67611523015E-2</c:v>
                </c:pt>
                <c:pt idx="34">
                  <c:v>8.0454730372599995E-2</c:v>
                </c:pt>
                <c:pt idx="35">
                  <c:v>4.3585855586999997E-2</c:v>
                </c:pt>
                <c:pt idx="36">
                  <c:v>0.17095409619599999</c:v>
                </c:pt>
                <c:pt idx="37">
                  <c:v>0.153674861838</c:v>
                </c:pt>
                <c:pt idx="38">
                  <c:v>0.30484951865900001</c:v>
                </c:pt>
                <c:pt idx="39">
                  <c:v>0.20301586777399999</c:v>
                </c:pt>
                <c:pt idx="40">
                  <c:v>0.19282760277</c:v>
                </c:pt>
                <c:pt idx="41">
                  <c:v>1.2393395374000001E-2</c:v>
                </c:pt>
                <c:pt idx="42">
                  <c:v>0.48109311703899998</c:v>
                </c:pt>
                <c:pt idx="43">
                  <c:v>0.39427509440699998</c:v>
                </c:pt>
                <c:pt idx="44">
                  <c:v>4.8641519681099997E-2</c:v>
                </c:pt>
                <c:pt idx="45">
                  <c:v>0.11746648160000001</c:v>
                </c:pt>
                <c:pt idx="46">
                  <c:v>0.15733827335299999</c:v>
                </c:pt>
                <c:pt idx="47">
                  <c:v>0.17784481383699999</c:v>
                </c:pt>
                <c:pt idx="48">
                  <c:v>0.434168760278</c:v>
                </c:pt>
                <c:pt idx="49">
                  <c:v>0.21692040046800001</c:v>
                </c:pt>
                <c:pt idx="50">
                  <c:v>8.13518882582E-2</c:v>
                </c:pt>
                <c:pt idx="51">
                  <c:v>0.49589798685499997</c:v>
                </c:pt>
                <c:pt idx="52">
                  <c:v>0.21828802408100001</c:v>
                </c:pt>
                <c:pt idx="53">
                  <c:v>0.35819149693000002</c:v>
                </c:pt>
                <c:pt idx="54">
                  <c:v>0.105429634201</c:v>
                </c:pt>
                <c:pt idx="55">
                  <c:v>0.456446580702</c:v>
                </c:pt>
                <c:pt idx="56">
                  <c:v>0.46772018267400001</c:v>
                </c:pt>
                <c:pt idx="57">
                  <c:v>0.211072899201</c:v>
                </c:pt>
                <c:pt idx="58">
                  <c:v>0.14516045723500001</c:v>
                </c:pt>
                <c:pt idx="59">
                  <c:v>0.26472650291200001</c:v>
                </c:pt>
                <c:pt idx="60">
                  <c:v>0.105979945748</c:v>
                </c:pt>
                <c:pt idx="61">
                  <c:v>0.39634967774300001</c:v>
                </c:pt>
                <c:pt idx="62">
                  <c:v>8.7308384310100004E-2</c:v>
                </c:pt>
                <c:pt idx="63">
                  <c:v>0.35440092513900001</c:v>
                </c:pt>
                <c:pt idx="64">
                  <c:v>3.09156491433E-2</c:v>
                </c:pt>
                <c:pt idx="65">
                  <c:v>0.12692940609100001</c:v>
                </c:pt>
                <c:pt idx="66">
                  <c:v>1.19579253201E-2</c:v>
                </c:pt>
                <c:pt idx="67">
                  <c:v>0.36023194008199999</c:v>
                </c:pt>
                <c:pt idx="68">
                  <c:v>0.45691894108499997</c:v>
                </c:pt>
                <c:pt idx="69">
                  <c:v>0.244857924936</c:v>
                </c:pt>
                <c:pt idx="70">
                  <c:v>0.23857767583299999</c:v>
                </c:pt>
                <c:pt idx="71">
                  <c:v>0.36491315884199998</c:v>
                </c:pt>
                <c:pt idx="72">
                  <c:v>0.34464338290800001</c:v>
                </c:pt>
                <c:pt idx="73">
                  <c:v>0.40155824167300003</c:v>
                </c:pt>
                <c:pt idx="74">
                  <c:v>0.932992297149</c:v>
                </c:pt>
                <c:pt idx="75">
                  <c:v>0</c:v>
                </c:pt>
                <c:pt idx="76">
                  <c:v>2.8411422942600001E-3</c:v>
                </c:pt>
                <c:pt idx="77">
                  <c:v>0.95334754958599999</c:v>
                </c:pt>
                <c:pt idx="78">
                  <c:v>0.31283185840700001</c:v>
                </c:pt>
                <c:pt idx="79">
                  <c:v>0.39953809493999998</c:v>
                </c:pt>
                <c:pt idx="80">
                  <c:v>0.15956796860299999</c:v>
                </c:pt>
                <c:pt idx="81">
                  <c:v>6.6638014679300001E-2</c:v>
                </c:pt>
                <c:pt idx="82">
                  <c:v>0.63976465606400001</c:v>
                </c:pt>
                <c:pt idx="83">
                  <c:v>0.198713361575</c:v>
                </c:pt>
                <c:pt idx="84">
                  <c:v>4.6787559073899997E-2</c:v>
                </c:pt>
                <c:pt idx="85">
                  <c:v>0.123485414882</c:v>
                </c:pt>
                <c:pt idx="86">
                  <c:v>0.33217966050499997</c:v>
                </c:pt>
                <c:pt idx="87">
                  <c:v>0.75357556589999997</c:v>
                </c:pt>
                <c:pt idx="88">
                  <c:v>0.244320250387</c:v>
                </c:pt>
                <c:pt idx="89">
                  <c:v>0.17698296461900001</c:v>
                </c:pt>
                <c:pt idx="90">
                  <c:v>0.25071088099</c:v>
                </c:pt>
                <c:pt idx="91">
                  <c:v>0.475168781697</c:v>
                </c:pt>
                <c:pt idx="92">
                  <c:v>0.61531821356399996</c:v>
                </c:pt>
                <c:pt idx="93">
                  <c:v>0.20998858991399999</c:v>
                </c:pt>
                <c:pt idx="94">
                  <c:v>0.56441526766600003</c:v>
                </c:pt>
                <c:pt idx="95">
                  <c:v>0.129250363088</c:v>
                </c:pt>
                <c:pt idx="96">
                  <c:v>4.0908453539200001E-2</c:v>
                </c:pt>
                <c:pt idx="97">
                  <c:v>6.8313298683199998E-3</c:v>
                </c:pt>
                <c:pt idx="98">
                  <c:v>3.1927749051099998E-2</c:v>
                </c:pt>
                <c:pt idx="99">
                  <c:v>0.64743445810599998</c:v>
                </c:pt>
                <c:pt idx="100">
                  <c:v>0.31441441188399999</c:v>
                </c:pt>
                <c:pt idx="101">
                  <c:v>0.208095255177</c:v>
                </c:pt>
                <c:pt idx="102">
                  <c:v>6.5995756611199996E-2</c:v>
                </c:pt>
                <c:pt idx="103">
                  <c:v>0.70381765566400001</c:v>
                </c:pt>
                <c:pt idx="104">
                  <c:v>0.112197784062</c:v>
                </c:pt>
                <c:pt idx="105">
                  <c:v>5.1425208198100002E-2</c:v>
                </c:pt>
                <c:pt idx="106">
                  <c:v>0.46370652316799998</c:v>
                </c:pt>
                <c:pt idx="107">
                  <c:v>2.5128328797299999E-2</c:v>
                </c:pt>
                <c:pt idx="108">
                  <c:v>2.43077855382E-2</c:v>
                </c:pt>
                <c:pt idx="109">
                  <c:v>0.87290889458400001</c:v>
                </c:pt>
                <c:pt idx="110">
                  <c:v>0.14832225985299999</c:v>
                </c:pt>
                <c:pt idx="111">
                  <c:v>0.35606982334699999</c:v>
                </c:pt>
                <c:pt idx="112">
                  <c:v>0.21654256622099999</c:v>
                </c:pt>
                <c:pt idx="113">
                  <c:v>2.4623644715999998E-3</c:v>
                </c:pt>
                <c:pt idx="114">
                  <c:v>7.5070673288900006E-2</c:v>
                </c:pt>
                <c:pt idx="115">
                  <c:v>5.38751002225E-2</c:v>
                </c:pt>
                <c:pt idx="116">
                  <c:v>0.31030076666</c:v>
                </c:pt>
                <c:pt idx="117">
                  <c:v>0.48720258270200001</c:v>
                </c:pt>
                <c:pt idx="118">
                  <c:v>5.9287001833499997E-2</c:v>
                </c:pt>
                <c:pt idx="119">
                  <c:v>0.84121031261599999</c:v>
                </c:pt>
                <c:pt idx="120">
                  <c:v>3.5269919003399999E-2</c:v>
                </c:pt>
                <c:pt idx="121">
                  <c:v>0.20989733900900001</c:v>
                </c:pt>
                <c:pt idx="122">
                  <c:v>0.320460681453</c:v>
                </c:pt>
                <c:pt idx="123">
                  <c:v>3.25205145825E-2</c:v>
                </c:pt>
                <c:pt idx="124">
                  <c:v>0.30581148703700001</c:v>
                </c:pt>
                <c:pt idx="125">
                  <c:v>0.48838674707099999</c:v>
                </c:pt>
                <c:pt idx="126">
                  <c:v>0.91445384127600005</c:v>
                </c:pt>
                <c:pt idx="127">
                  <c:v>0.136747239948</c:v>
                </c:pt>
                <c:pt idx="128">
                  <c:v>0.13079199566399999</c:v>
                </c:pt>
                <c:pt idx="129">
                  <c:v>0.56732668976699996</c:v>
                </c:pt>
                <c:pt idx="130">
                  <c:v>0.87685588069200004</c:v>
                </c:pt>
                <c:pt idx="131">
                  <c:v>0.51225355534299999</c:v>
                </c:pt>
                <c:pt idx="132">
                  <c:v>0.93743279636200005</c:v>
                </c:pt>
                <c:pt idx="133">
                  <c:v>0.40937947713599998</c:v>
                </c:pt>
                <c:pt idx="134">
                  <c:v>4.2297776345500001E-4</c:v>
                </c:pt>
                <c:pt idx="135">
                  <c:v>0.84264293849600003</c:v>
                </c:pt>
                <c:pt idx="136">
                  <c:v>7.0834929590200005E-2</c:v>
                </c:pt>
                <c:pt idx="137">
                  <c:v>0.30846663585900003</c:v>
                </c:pt>
                <c:pt idx="138">
                  <c:v>0.59578765147099999</c:v>
                </c:pt>
                <c:pt idx="139">
                  <c:v>0.267005721551</c:v>
                </c:pt>
                <c:pt idx="140">
                  <c:v>0.213249461946</c:v>
                </c:pt>
                <c:pt idx="141">
                  <c:v>0.50120118442399997</c:v>
                </c:pt>
                <c:pt idx="142">
                  <c:v>0.84436404899899997</c:v>
                </c:pt>
                <c:pt idx="143">
                  <c:v>0.16955328730200001</c:v>
                </c:pt>
                <c:pt idx="144">
                  <c:v>0.18285425253699999</c:v>
                </c:pt>
                <c:pt idx="145">
                  <c:v>0.26316652065200002</c:v>
                </c:pt>
                <c:pt idx="146">
                  <c:v>0.24169302420899999</c:v>
                </c:pt>
                <c:pt idx="147">
                  <c:v>0.20029901404600001</c:v>
                </c:pt>
                <c:pt idx="148">
                  <c:v>0.67073983172200002</c:v>
                </c:pt>
                <c:pt idx="149">
                  <c:v>0.96975883026999998</c:v>
                </c:pt>
                <c:pt idx="150">
                  <c:v>0.20018115675500001</c:v>
                </c:pt>
                <c:pt idx="151">
                  <c:v>3.2936072638899999E-2</c:v>
                </c:pt>
                <c:pt idx="152">
                  <c:v>5.4366693671199999E-2</c:v>
                </c:pt>
                <c:pt idx="153">
                  <c:v>8.5776729312899994E-2</c:v>
                </c:pt>
                <c:pt idx="154">
                  <c:v>1.8532145768699999E-2</c:v>
                </c:pt>
                <c:pt idx="155">
                  <c:v>0.168671584795</c:v>
                </c:pt>
                <c:pt idx="156">
                  <c:v>1.2940660599699999E-2</c:v>
                </c:pt>
                <c:pt idx="157">
                  <c:v>3.2355278290399997E-2</c:v>
                </c:pt>
                <c:pt idx="158">
                  <c:v>4.3851715711000001E-2</c:v>
                </c:pt>
                <c:pt idx="159">
                  <c:v>0.28861370751799997</c:v>
                </c:pt>
                <c:pt idx="160">
                  <c:v>0.79364736796299995</c:v>
                </c:pt>
                <c:pt idx="161">
                  <c:v>0.27023106807199998</c:v>
                </c:pt>
                <c:pt idx="162">
                  <c:v>5.2034410222500001E-3</c:v>
                </c:pt>
                <c:pt idx="163">
                  <c:v>0.41290784117099999</c:v>
                </c:pt>
                <c:pt idx="164">
                  <c:v>4.3524598149599997E-2</c:v>
                </c:pt>
                <c:pt idx="165">
                  <c:v>0.35188622972799999</c:v>
                </c:pt>
                <c:pt idx="166">
                  <c:v>0.31483808687300002</c:v>
                </c:pt>
                <c:pt idx="167">
                  <c:v>6.2199322661900001E-2</c:v>
                </c:pt>
                <c:pt idx="168">
                  <c:v>0.66522959872099996</c:v>
                </c:pt>
                <c:pt idx="169">
                  <c:v>0.69236016485899998</c:v>
                </c:pt>
                <c:pt idx="170">
                  <c:v>0.16783945790999999</c:v>
                </c:pt>
                <c:pt idx="171">
                  <c:v>8.9270611179500005E-3</c:v>
                </c:pt>
                <c:pt idx="172">
                  <c:v>7.0468462264000001E-3</c:v>
                </c:pt>
                <c:pt idx="173">
                  <c:v>1.23686084215E-2</c:v>
                </c:pt>
                <c:pt idx="174">
                  <c:v>0.21012167207400001</c:v>
                </c:pt>
                <c:pt idx="175">
                  <c:v>1.7075166232400001E-2</c:v>
                </c:pt>
                <c:pt idx="176">
                  <c:v>0.34609000895800002</c:v>
                </c:pt>
                <c:pt idx="177">
                  <c:v>0.28593512043800001</c:v>
                </c:pt>
                <c:pt idx="178">
                  <c:v>2.8673815545800001E-2</c:v>
                </c:pt>
                <c:pt idx="179">
                  <c:v>0.59831612357999997</c:v>
                </c:pt>
                <c:pt idx="180">
                  <c:v>0.105762369767</c:v>
                </c:pt>
                <c:pt idx="181">
                  <c:v>7.8377174833300006E-2</c:v>
                </c:pt>
                <c:pt idx="182">
                  <c:v>4.5512229660900003E-2</c:v>
                </c:pt>
                <c:pt idx="183">
                  <c:v>0.18362967295499999</c:v>
                </c:pt>
                <c:pt idx="184">
                  <c:v>0.20620056709000001</c:v>
                </c:pt>
                <c:pt idx="185">
                  <c:v>1.13526559766E-2</c:v>
                </c:pt>
                <c:pt idx="186">
                  <c:v>9.75883229953E-2</c:v>
                </c:pt>
                <c:pt idx="187">
                  <c:v>0</c:v>
                </c:pt>
                <c:pt idx="188">
                  <c:v>0.34398695710400001</c:v>
                </c:pt>
                <c:pt idx="189">
                  <c:v>0.19919683590699999</c:v>
                </c:pt>
                <c:pt idx="190">
                  <c:v>6.5164189543900006E-2</c:v>
                </c:pt>
                <c:pt idx="191">
                  <c:v>7.7660819904999998E-2</c:v>
                </c:pt>
                <c:pt idx="192">
                  <c:v>0.12701551268899999</c:v>
                </c:pt>
                <c:pt idx="193">
                  <c:v>0.104806428711</c:v>
                </c:pt>
                <c:pt idx="194">
                  <c:v>7.1410412829299996E-2</c:v>
                </c:pt>
                <c:pt idx="195">
                  <c:v>9.5157463860500002E-2</c:v>
                </c:pt>
                <c:pt idx="196">
                  <c:v>7.9700129664500005E-2</c:v>
                </c:pt>
                <c:pt idx="197">
                  <c:v>0.10095947345799999</c:v>
                </c:pt>
                <c:pt idx="198">
                  <c:v>9.1496781565599997E-2</c:v>
                </c:pt>
                <c:pt idx="199">
                  <c:v>0.46142839588899998</c:v>
                </c:pt>
                <c:pt idx="200">
                  <c:v>0.40302188259799998</c:v>
                </c:pt>
                <c:pt idx="201">
                  <c:v>0.432481098244</c:v>
                </c:pt>
                <c:pt idx="202">
                  <c:v>0.502039160092</c:v>
                </c:pt>
                <c:pt idx="203">
                  <c:v>0.30525113489799999</c:v>
                </c:pt>
                <c:pt idx="204">
                  <c:v>0.89940691900600001</c:v>
                </c:pt>
                <c:pt idx="205">
                  <c:v>0.39343877068700001</c:v>
                </c:pt>
                <c:pt idx="206">
                  <c:v>0.23725329499799999</c:v>
                </c:pt>
                <c:pt idx="207">
                  <c:v>0.163456577278</c:v>
                </c:pt>
                <c:pt idx="208">
                  <c:v>0.22017418766899999</c:v>
                </c:pt>
                <c:pt idx="209">
                  <c:v>0.42262583442200002</c:v>
                </c:pt>
                <c:pt idx="210">
                  <c:v>0.52792623940000005</c:v>
                </c:pt>
                <c:pt idx="211">
                  <c:v>0.61517699334999998</c:v>
                </c:pt>
                <c:pt idx="212">
                  <c:v>0.42730153789699998</c:v>
                </c:pt>
                <c:pt idx="213">
                  <c:v>0.49113381431699998</c:v>
                </c:pt>
                <c:pt idx="214">
                  <c:v>0.72573760908100005</c:v>
                </c:pt>
                <c:pt idx="215">
                  <c:v>0.61013208121200002</c:v>
                </c:pt>
                <c:pt idx="216">
                  <c:v>0.66428380811700005</c:v>
                </c:pt>
                <c:pt idx="217">
                  <c:v>0.69941810499699997</c:v>
                </c:pt>
                <c:pt idx="218">
                  <c:v>0.65030562270699999</c:v>
                </c:pt>
                <c:pt idx="219">
                  <c:v>0.69949814218799999</c:v>
                </c:pt>
                <c:pt idx="220">
                  <c:v>0.68317093501600001</c:v>
                </c:pt>
                <c:pt idx="221">
                  <c:v>0.66932507304800004</c:v>
                </c:pt>
                <c:pt idx="222">
                  <c:v>0.50512542104699998</c:v>
                </c:pt>
                <c:pt idx="223">
                  <c:v>0.63186719046899997</c:v>
                </c:pt>
                <c:pt idx="224">
                  <c:v>0.62146492532099995</c:v>
                </c:pt>
                <c:pt idx="225">
                  <c:v>0.66032530141500001</c:v>
                </c:pt>
                <c:pt idx="226">
                  <c:v>0.606676041896</c:v>
                </c:pt>
                <c:pt idx="227">
                  <c:v>0.61955276050800001</c:v>
                </c:pt>
                <c:pt idx="228">
                  <c:v>0.66003714919699996</c:v>
                </c:pt>
                <c:pt idx="229">
                  <c:v>0.66567056577499994</c:v>
                </c:pt>
                <c:pt idx="230">
                  <c:v>0.70335241930900005</c:v>
                </c:pt>
                <c:pt idx="231">
                  <c:v>0.68860646523199998</c:v>
                </c:pt>
                <c:pt idx="232">
                  <c:v>0.72110026546899997</c:v>
                </c:pt>
                <c:pt idx="233">
                  <c:v>0.67863802555999997</c:v>
                </c:pt>
                <c:pt idx="234">
                  <c:v>0.60895751328100001</c:v>
                </c:pt>
                <c:pt idx="235">
                  <c:v>0.67623770184499998</c:v>
                </c:pt>
                <c:pt idx="236">
                  <c:v>0.68252260126200004</c:v>
                </c:pt>
                <c:pt idx="237">
                  <c:v>0.68202132098099999</c:v>
                </c:pt>
                <c:pt idx="238">
                  <c:v>0.65820664933799999</c:v>
                </c:pt>
                <c:pt idx="239">
                  <c:v>0.525738117394</c:v>
                </c:pt>
                <c:pt idx="240">
                  <c:v>0.534575323677</c:v>
                </c:pt>
                <c:pt idx="241">
                  <c:v>0.55152902609700005</c:v>
                </c:pt>
                <c:pt idx="242">
                  <c:v>0.57994928414199998</c:v>
                </c:pt>
                <c:pt idx="243">
                  <c:v>0.604918145314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6038784"/>
        <c:axId val="258912640"/>
      </c:barChart>
      <c:catAx>
        <c:axId val="2560387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Samples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crossAx val="258912640"/>
        <c:crosses val="autoZero"/>
        <c:auto val="1"/>
        <c:lblAlgn val="ctr"/>
        <c:lblOffset val="100"/>
        <c:noMultiLvlLbl val="0"/>
      </c:catAx>
      <c:valAx>
        <c:axId val="258912640"/>
        <c:scaling>
          <c:orientation val="minMax"/>
          <c:max val="1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Percent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56038784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altLang="zh-CN" sz="1600"/>
              <a:t>Percent of the microbes with the phenotype of </a:t>
            </a:r>
            <a:r>
              <a:rPr lang="en-US" altLang="en-US" sz="1600"/>
              <a:t>Stress Tolerant</a:t>
            </a:r>
            <a:r>
              <a:rPr lang="en-US" altLang="en-US" sz="1600" baseline="0"/>
              <a:t> </a:t>
            </a:r>
            <a:r>
              <a:rPr lang="en-US" altLang="zh-CN" sz="1600" baseline="0"/>
              <a:t>in each sample</a:t>
            </a:r>
            <a:endParaRPr lang="en-US" altLang="en-US" sz="160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5.1992391400513135E-2"/>
          <c:y val="0.19480351414406533"/>
          <c:w val="0.93427477464193376"/>
          <c:h val="0.365747474747474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表型预测结果表!$A$13</c:f>
              <c:strCache>
                <c:ptCount val="1"/>
                <c:pt idx="0">
                  <c:v>Stress_Tolerant</c:v>
                </c:pt>
              </c:strCache>
            </c:strRef>
          </c:tx>
          <c:invertIfNegative val="0"/>
          <c:cat>
            <c:strRef>
              <c:f>表型预测结果表!$B$12:$IK$12</c:f>
              <c:strCache>
                <c:ptCount val="244"/>
                <c:pt idx="0">
                  <c:v>AN20220701</c:v>
                </c:pt>
                <c:pt idx="1">
                  <c:v>AN20220702</c:v>
                </c:pt>
                <c:pt idx="2">
                  <c:v>AN20220703</c:v>
                </c:pt>
                <c:pt idx="3">
                  <c:v>AN20220704</c:v>
                </c:pt>
                <c:pt idx="4">
                  <c:v>AN20220705</c:v>
                </c:pt>
                <c:pt idx="5">
                  <c:v>CB20220701</c:v>
                </c:pt>
                <c:pt idx="6">
                  <c:v>CB20220702</c:v>
                </c:pt>
                <c:pt idx="7">
                  <c:v>CB20220703</c:v>
                </c:pt>
                <c:pt idx="8">
                  <c:v>CB20220704</c:v>
                </c:pt>
                <c:pt idx="9">
                  <c:v>CB20220705</c:v>
                </c:pt>
                <c:pt idx="10">
                  <c:v>CB20220706</c:v>
                </c:pt>
                <c:pt idx="11">
                  <c:v>CB20220707</c:v>
                </c:pt>
                <c:pt idx="12">
                  <c:v>CB20220708</c:v>
                </c:pt>
                <c:pt idx="13">
                  <c:v>CB20220709</c:v>
                </c:pt>
                <c:pt idx="14">
                  <c:v>CB20220710</c:v>
                </c:pt>
                <c:pt idx="15">
                  <c:v>CB20220711</c:v>
                </c:pt>
                <c:pt idx="16">
                  <c:v>CB20220712</c:v>
                </c:pt>
                <c:pt idx="17">
                  <c:v>CB20220713</c:v>
                </c:pt>
                <c:pt idx="18">
                  <c:v>CB20220714</c:v>
                </c:pt>
                <c:pt idx="19">
                  <c:v>CB20220715</c:v>
                </c:pt>
                <c:pt idx="20">
                  <c:v>CB20220716</c:v>
                </c:pt>
                <c:pt idx="21">
                  <c:v>CB20220717</c:v>
                </c:pt>
                <c:pt idx="22">
                  <c:v>CB20220718</c:v>
                </c:pt>
                <c:pt idx="23">
                  <c:v>CB20220719</c:v>
                </c:pt>
                <c:pt idx="24">
                  <c:v>CB20220720</c:v>
                </c:pt>
                <c:pt idx="25">
                  <c:v>CB20220721</c:v>
                </c:pt>
                <c:pt idx="26">
                  <c:v>CB20220722</c:v>
                </c:pt>
                <c:pt idx="27">
                  <c:v>CB20220723</c:v>
                </c:pt>
                <c:pt idx="28">
                  <c:v>CB20220724</c:v>
                </c:pt>
                <c:pt idx="29">
                  <c:v>CB20220725</c:v>
                </c:pt>
                <c:pt idx="30">
                  <c:v>CB20220726</c:v>
                </c:pt>
                <c:pt idx="31">
                  <c:v>CB20220727</c:v>
                </c:pt>
                <c:pt idx="32">
                  <c:v>CB20220728</c:v>
                </c:pt>
                <c:pt idx="33">
                  <c:v>CB20220729</c:v>
                </c:pt>
                <c:pt idx="34">
                  <c:v>CB20220730</c:v>
                </c:pt>
                <c:pt idx="35">
                  <c:v>CB20220731</c:v>
                </c:pt>
                <c:pt idx="36">
                  <c:v>CH20220701</c:v>
                </c:pt>
                <c:pt idx="37">
                  <c:v>CH20220702</c:v>
                </c:pt>
                <c:pt idx="38">
                  <c:v>CH20220703</c:v>
                </c:pt>
                <c:pt idx="39">
                  <c:v>CH20220704</c:v>
                </c:pt>
                <c:pt idx="40">
                  <c:v>CH20220705</c:v>
                </c:pt>
                <c:pt idx="41">
                  <c:v>CH20220706</c:v>
                </c:pt>
                <c:pt idx="42">
                  <c:v>CH20220707</c:v>
                </c:pt>
                <c:pt idx="43">
                  <c:v>CH20220708</c:v>
                </c:pt>
                <c:pt idx="44">
                  <c:v>CH20220709</c:v>
                </c:pt>
                <c:pt idx="45">
                  <c:v>CH20220710</c:v>
                </c:pt>
                <c:pt idx="46">
                  <c:v>CH20220711</c:v>
                </c:pt>
                <c:pt idx="47">
                  <c:v>CH20220712</c:v>
                </c:pt>
                <c:pt idx="48">
                  <c:v>CH20220713</c:v>
                </c:pt>
                <c:pt idx="49">
                  <c:v>CH20220714</c:v>
                </c:pt>
                <c:pt idx="50">
                  <c:v>CH20220715</c:v>
                </c:pt>
                <c:pt idx="51">
                  <c:v>CH20220716</c:v>
                </c:pt>
                <c:pt idx="52">
                  <c:v>CH20220717</c:v>
                </c:pt>
                <c:pt idx="53">
                  <c:v>CH20220718</c:v>
                </c:pt>
                <c:pt idx="54">
                  <c:v>CH20220719</c:v>
                </c:pt>
                <c:pt idx="55">
                  <c:v>CH20220720</c:v>
                </c:pt>
                <c:pt idx="56">
                  <c:v>CH20220721</c:v>
                </c:pt>
                <c:pt idx="57">
                  <c:v>CH20220722</c:v>
                </c:pt>
                <c:pt idx="58">
                  <c:v>CH20220723</c:v>
                </c:pt>
                <c:pt idx="59">
                  <c:v>CH20220724</c:v>
                </c:pt>
                <c:pt idx="60">
                  <c:v>CH20220725</c:v>
                </c:pt>
                <c:pt idx="61">
                  <c:v>CH20220726</c:v>
                </c:pt>
                <c:pt idx="62">
                  <c:v>CH20220727</c:v>
                </c:pt>
                <c:pt idx="63">
                  <c:v>CH20220728</c:v>
                </c:pt>
                <c:pt idx="64">
                  <c:v>CH20220729</c:v>
                </c:pt>
                <c:pt idx="65">
                  <c:v>CH20220730</c:v>
                </c:pt>
                <c:pt idx="66">
                  <c:v>CH20220731</c:v>
                </c:pt>
                <c:pt idx="67">
                  <c:v>CH20220732</c:v>
                </c:pt>
                <c:pt idx="68">
                  <c:v>CH20220733</c:v>
                </c:pt>
                <c:pt idx="69">
                  <c:v>CH20220734</c:v>
                </c:pt>
                <c:pt idx="70">
                  <c:v>CH20220735</c:v>
                </c:pt>
                <c:pt idx="71">
                  <c:v>HM20220701</c:v>
                </c:pt>
                <c:pt idx="72">
                  <c:v>HM20220702</c:v>
                </c:pt>
                <c:pt idx="73">
                  <c:v>HM20220703</c:v>
                </c:pt>
                <c:pt idx="74">
                  <c:v>HM20220704</c:v>
                </c:pt>
                <c:pt idx="75">
                  <c:v>LC20220701</c:v>
                </c:pt>
                <c:pt idx="76">
                  <c:v>LC20220702</c:v>
                </c:pt>
                <c:pt idx="77">
                  <c:v>LC20220703</c:v>
                </c:pt>
                <c:pt idx="78">
                  <c:v>LC20220704</c:v>
                </c:pt>
                <c:pt idx="79">
                  <c:v>LC20220705</c:v>
                </c:pt>
                <c:pt idx="80">
                  <c:v>LC20220706</c:v>
                </c:pt>
                <c:pt idx="81">
                  <c:v>LC20220707</c:v>
                </c:pt>
                <c:pt idx="82">
                  <c:v>LC20220708</c:v>
                </c:pt>
                <c:pt idx="83">
                  <c:v>LC20220709</c:v>
                </c:pt>
                <c:pt idx="84">
                  <c:v>LC20220710</c:v>
                </c:pt>
                <c:pt idx="85">
                  <c:v>LC20220711</c:v>
                </c:pt>
                <c:pt idx="86">
                  <c:v>LC20220712</c:v>
                </c:pt>
                <c:pt idx="87">
                  <c:v>LC20220713</c:v>
                </c:pt>
                <c:pt idx="88">
                  <c:v>LC20220714</c:v>
                </c:pt>
                <c:pt idx="89">
                  <c:v>LC20220715</c:v>
                </c:pt>
                <c:pt idx="90">
                  <c:v>LC20220716</c:v>
                </c:pt>
                <c:pt idx="91">
                  <c:v>LC20220717</c:v>
                </c:pt>
                <c:pt idx="92">
                  <c:v>LC20220718</c:v>
                </c:pt>
                <c:pt idx="93">
                  <c:v>LC20220719</c:v>
                </c:pt>
                <c:pt idx="94">
                  <c:v>LC20220720</c:v>
                </c:pt>
                <c:pt idx="95">
                  <c:v>LC20220721</c:v>
                </c:pt>
                <c:pt idx="96">
                  <c:v>LC20220722</c:v>
                </c:pt>
                <c:pt idx="97">
                  <c:v>LC20220723</c:v>
                </c:pt>
                <c:pt idx="98">
                  <c:v>LC20220724</c:v>
                </c:pt>
                <c:pt idx="99">
                  <c:v>LC20220725</c:v>
                </c:pt>
                <c:pt idx="100">
                  <c:v>LC20220726</c:v>
                </c:pt>
                <c:pt idx="101">
                  <c:v>LC20220727</c:v>
                </c:pt>
                <c:pt idx="102">
                  <c:v>LC20220728</c:v>
                </c:pt>
                <c:pt idx="103">
                  <c:v>LC20220729</c:v>
                </c:pt>
                <c:pt idx="104">
                  <c:v>LC20220730</c:v>
                </c:pt>
                <c:pt idx="105">
                  <c:v>LC20220731</c:v>
                </c:pt>
                <c:pt idx="106">
                  <c:v>LL20220701</c:v>
                </c:pt>
                <c:pt idx="107">
                  <c:v>LL20220702</c:v>
                </c:pt>
                <c:pt idx="108">
                  <c:v>LL20220703</c:v>
                </c:pt>
                <c:pt idx="109">
                  <c:v>LL20220704</c:v>
                </c:pt>
                <c:pt idx="110">
                  <c:v>LL20220705</c:v>
                </c:pt>
                <c:pt idx="111">
                  <c:v>LL20220706</c:v>
                </c:pt>
                <c:pt idx="112">
                  <c:v>LL20220707</c:v>
                </c:pt>
                <c:pt idx="113">
                  <c:v>LL20220708</c:v>
                </c:pt>
                <c:pt idx="114">
                  <c:v>LL20220709</c:v>
                </c:pt>
                <c:pt idx="115">
                  <c:v>LL20220710</c:v>
                </c:pt>
                <c:pt idx="116">
                  <c:v>LL20220711</c:v>
                </c:pt>
                <c:pt idx="117">
                  <c:v>LL20220712</c:v>
                </c:pt>
                <c:pt idx="118">
                  <c:v>LL20220713</c:v>
                </c:pt>
                <c:pt idx="119">
                  <c:v>LL20220714</c:v>
                </c:pt>
                <c:pt idx="120">
                  <c:v>LL20220715</c:v>
                </c:pt>
                <c:pt idx="121">
                  <c:v>LL20220716</c:v>
                </c:pt>
                <c:pt idx="122">
                  <c:v>LL20220717</c:v>
                </c:pt>
                <c:pt idx="123">
                  <c:v>LL20220718</c:v>
                </c:pt>
                <c:pt idx="124">
                  <c:v>LL20220719</c:v>
                </c:pt>
                <c:pt idx="125">
                  <c:v>LL20220720</c:v>
                </c:pt>
                <c:pt idx="126">
                  <c:v>LL20220721</c:v>
                </c:pt>
                <c:pt idx="127">
                  <c:v>LL20220722</c:v>
                </c:pt>
                <c:pt idx="128">
                  <c:v>LL20220723</c:v>
                </c:pt>
                <c:pt idx="129">
                  <c:v>LL20220724</c:v>
                </c:pt>
                <c:pt idx="130">
                  <c:v>LL20220725</c:v>
                </c:pt>
                <c:pt idx="131">
                  <c:v>LL20220726</c:v>
                </c:pt>
                <c:pt idx="132">
                  <c:v>LL20220727</c:v>
                </c:pt>
                <c:pt idx="133">
                  <c:v>LL20220728</c:v>
                </c:pt>
                <c:pt idx="134">
                  <c:v>LL20220729</c:v>
                </c:pt>
                <c:pt idx="135">
                  <c:v>LL20220730</c:v>
                </c:pt>
                <c:pt idx="136">
                  <c:v>LL20220731</c:v>
                </c:pt>
                <c:pt idx="137">
                  <c:v>LL20220732</c:v>
                </c:pt>
                <c:pt idx="138">
                  <c:v>LL20220733</c:v>
                </c:pt>
                <c:pt idx="139">
                  <c:v>LL20220734</c:v>
                </c:pt>
                <c:pt idx="140">
                  <c:v>LL20220735</c:v>
                </c:pt>
                <c:pt idx="141">
                  <c:v>LL20220736</c:v>
                </c:pt>
                <c:pt idx="142">
                  <c:v>LL20220737</c:v>
                </c:pt>
                <c:pt idx="143">
                  <c:v>LL20220738</c:v>
                </c:pt>
                <c:pt idx="144">
                  <c:v>LL20220739</c:v>
                </c:pt>
                <c:pt idx="145">
                  <c:v>LL20220740</c:v>
                </c:pt>
                <c:pt idx="146">
                  <c:v>LL20220741</c:v>
                </c:pt>
                <c:pt idx="147">
                  <c:v>PF20220701</c:v>
                </c:pt>
                <c:pt idx="148">
                  <c:v>PF20220702</c:v>
                </c:pt>
                <c:pt idx="149">
                  <c:v>PF20220703</c:v>
                </c:pt>
                <c:pt idx="150">
                  <c:v>PF20220704</c:v>
                </c:pt>
                <c:pt idx="151">
                  <c:v>PF20220705</c:v>
                </c:pt>
                <c:pt idx="152">
                  <c:v>PF20220706</c:v>
                </c:pt>
                <c:pt idx="153">
                  <c:v>PF20220707</c:v>
                </c:pt>
                <c:pt idx="154">
                  <c:v>PF20220708</c:v>
                </c:pt>
                <c:pt idx="155">
                  <c:v>PF20220709</c:v>
                </c:pt>
                <c:pt idx="156">
                  <c:v>PF20220710</c:v>
                </c:pt>
                <c:pt idx="157">
                  <c:v>PF20220711</c:v>
                </c:pt>
                <c:pt idx="158">
                  <c:v>PF20220712</c:v>
                </c:pt>
                <c:pt idx="159">
                  <c:v>PF20220713</c:v>
                </c:pt>
                <c:pt idx="160">
                  <c:v>PF20220714</c:v>
                </c:pt>
                <c:pt idx="161">
                  <c:v>PF20220715</c:v>
                </c:pt>
                <c:pt idx="162">
                  <c:v>PF20220716</c:v>
                </c:pt>
                <c:pt idx="163">
                  <c:v>PN20220701</c:v>
                </c:pt>
                <c:pt idx="164">
                  <c:v>PN20220702</c:v>
                </c:pt>
                <c:pt idx="165">
                  <c:v>PN20220703</c:v>
                </c:pt>
                <c:pt idx="166">
                  <c:v>PN20220704</c:v>
                </c:pt>
                <c:pt idx="167">
                  <c:v>PN20220705</c:v>
                </c:pt>
                <c:pt idx="168">
                  <c:v>PN20220706</c:v>
                </c:pt>
                <c:pt idx="169">
                  <c:v>PN20220707</c:v>
                </c:pt>
                <c:pt idx="170">
                  <c:v>PN20220708</c:v>
                </c:pt>
                <c:pt idx="171">
                  <c:v>PN20220709</c:v>
                </c:pt>
                <c:pt idx="172">
                  <c:v>PN20220710</c:v>
                </c:pt>
                <c:pt idx="173">
                  <c:v>PN20220711</c:v>
                </c:pt>
                <c:pt idx="174">
                  <c:v>PT20220701</c:v>
                </c:pt>
                <c:pt idx="175">
                  <c:v>PT20220702</c:v>
                </c:pt>
                <c:pt idx="176">
                  <c:v>PT20220703</c:v>
                </c:pt>
                <c:pt idx="177">
                  <c:v>PT20220704</c:v>
                </c:pt>
                <c:pt idx="178">
                  <c:v>PT20220705</c:v>
                </c:pt>
                <c:pt idx="179">
                  <c:v>PT20220706</c:v>
                </c:pt>
                <c:pt idx="180">
                  <c:v>PV20220701</c:v>
                </c:pt>
                <c:pt idx="181">
                  <c:v>PV20220702</c:v>
                </c:pt>
                <c:pt idx="182">
                  <c:v>PV20220703</c:v>
                </c:pt>
                <c:pt idx="183">
                  <c:v>PV20220704</c:v>
                </c:pt>
                <c:pt idx="184">
                  <c:v>SC20220701</c:v>
                </c:pt>
                <c:pt idx="185">
                  <c:v>SC20220702</c:v>
                </c:pt>
                <c:pt idx="186">
                  <c:v>SC20220703</c:v>
                </c:pt>
                <c:pt idx="187">
                  <c:v>SC20220704</c:v>
                </c:pt>
                <c:pt idx="188">
                  <c:v>SC20220705</c:v>
                </c:pt>
                <c:pt idx="189">
                  <c:v>SC20220706</c:v>
                </c:pt>
                <c:pt idx="190">
                  <c:v>SC20220707</c:v>
                </c:pt>
                <c:pt idx="191">
                  <c:v>SC20220708</c:v>
                </c:pt>
                <c:pt idx="192">
                  <c:v>SC20220709</c:v>
                </c:pt>
                <c:pt idx="193">
                  <c:v>SK20220701</c:v>
                </c:pt>
                <c:pt idx="194">
                  <c:v>SK20220702</c:v>
                </c:pt>
                <c:pt idx="195">
                  <c:v>SK20220703</c:v>
                </c:pt>
                <c:pt idx="196">
                  <c:v>SK20220704</c:v>
                </c:pt>
                <c:pt idx="197">
                  <c:v>SK20220705</c:v>
                </c:pt>
                <c:pt idx="198">
                  <c:v>SM20220701</c:v>
                </c:pt>
                <c:pt idx="199">
                  <c:v>SM20220702</c:v>
                </c:pt>
                <c:pt idx="200">
                  <c:v>XA20220701</c:v>
                </c:pt>
                <c:pt idx="201">
                  <c:v>XA20220702</c:v>
                </c:pt>
                <c:pt idx="202">
                  <c:v>XA20220703</c:v>
                </c:pt>
                <c:pt idx="203">
                  <c:v>XA20220704</c:v>
                </c:pt>
                <c:pt idx="204">
                  <c:v>XA20220705</c:v>
                </c:pt>
                <c:pt idx="205">
                  <c:v>XA20220706</c:v>
                </c:pt>
                <c:pt idx="206">
                  <c:v>XA20220707</c:v>
                </c:pt>
                <c:pt idx="207">
                  <c:v>XA20220708</c:v>
                </c:pt>
                <c:pt idx="208">
                  <c:v>XA20220709</c:v>
                </c:pt>
                <c:pt idx="209">
                  <c:v>XA20220710</c:v>
                </c:pt>
                <c:pt idx="210">
                  <c:v>XA20220711</c:v>
                </c:pt>
                <c:pt idx="211">
                  <c:v>XA20220712</c:v>
                </c:pt>
                <c:pt idx="212">
                  <c:v>XA20220713</c:v>
                </c:pt>
                <c:pt idx="213">
                  <c:v>XA20220714</c:v>
                </c:pt>
                <c:pt idx="214">
                  <c:v>WHW20220701</c:v>
                </c:pt>
                <c:pt idx="215">
                  <c:v>WHW20220702A</c:v>
                </c:pt>
                <c:pt idx="216">
                  <c:v>WHW20220702B</c:v>
                </c:pt>
                <c:pt idx="217">
                  <c:v>WHW20220702C</c:v>
                </c:pt>
                <c:pt idx="218">
                  <c:v>WHW20220702D</c:v>
                </c:pt>
                <c:pt idx="219">
                  <c:v>WHW20220702E</c:v>
                </c:pt>
                <c:pt idx="220">
                  <c:v>WHW20220702F</c:v>
                </c:pt>
                <c:pt idx="221">
                  <c:v>WHW20220702G</c:v>
                </c:pt>
                <c:pt idx="222">
                  <c:v>WHW20220702H</c:v>
                </c:pt>
                <c:pt idx="223">
                  <c:v>WHW20220703</c:v>
                </c:pt>
                <c:pt idx="224">
                  <c:v>WHW20220704</c:v>
                </c:pt>
                <c:pt idx="225">
                  <c:v>WHW20220705</c:v>
                </c:pt>
                <c:pt idx="226">
                  <c:v>WHW20220706</c:v>
                </c:pt>
                <c:pt idx="227">
                  <c:v>WHW20220707</c:v>
                </c:pt>
                <c:pt idx="228">
                  <c:v>WHW20220708</c:v>
                </c:pt>
                <c:pt idx="229">
                  <c:v>WHW20220709</c:v>
                </c:pt>
                <c:pt idx="230">
                  <c:v>WHW20220710</c:v>
                </c:pt>
                <c:pt idx="231">
                  <c:v>WHW20220711</c:v>
                </c:pt>
                <c:pt idx="232">
                  <c:v>WHW20220712</c:v>
                </c:pt>
                <c:pt idx="233">
                  <c:v>WHW20220713</c:v>
                </c:pt>
                <c:pt idx="234">
                  <c:v>WHW20220714A</c:v>
                </c:pt>
                <c:pt idx="235">
                  <c:v>WHW20220714B</c:v>
                </c:pt>
                <c:pt idx="236">
                  <c:v>WHW20220714C</c:v>
                </c:pt>
                <c:pt idx="237">
                  <c:v>WHW20220714D</c:v>
                </c:pt>
                <c:pt idx="238">
                  <c:v>WHW20220714E</c:v>
                </c:pt>
                <c:pt idx="239">
                  <c:v>WHW20220714F</c:v>
                </c:pt>
                <c:pt idx="240">
                  <c:v>WHW20220714G</c:v>
                </c:pt>
                <c:pt idx="241">
                  <c:v>WHW20220714H</c:v>
                </c:pt>
                <c:pt idx="242">
                  <c:v>WHW20220715</c:v>
                </c:pt>
                <c:pt idx="243">
                  <c:v>WHW20220716</c:v>
                </c:pt>
              </c:strCache>
            </c:strRef>
          </c:cat>
          <c:val>
            <c:numRef>
              <c:f>表型预测结果表!$B$13:$IK$13</c:f>
              <c:numCache>
                <c:formatCode>General</c:formatCode>
                <c:ptCount val="244"/>
                <c:pt idx="0">
                  <c:v>8.5729921044800008E-3</c:v>
                </c:pt>
                <c:pt idx="1">
                  <c:v>0.31648233177700003</c:v>
                </c:pt>
                <c:pt idx="2">
                  <c:v>2.11605728715E-2</c:v>
                </c:pt>
                <c:pt idx="3">
                  <c:v>1.86970005281E-2</c:v>
                </c:pt>
                <c:pt idx="4">
                  <c:v>6.0873094092400003E-3</c:v>
                </c:pt>
                <c:pt idx="5">
                  <c:v>0.12062091146499999</c:v>
                </c:pt>
                <c:pt idx="6">
                  <c:v>0.67067479397800001</c:v>
                </c:pt>
                <c:pt idx="7">
                  <c:v>0.61509106597300001</c:v>
                </c:pt>
                <c:pt idx="8">
                  <c:v>0.15882145452599999</c:v>
                </c:pt>
                <c:pt idx="9">
                  <c:v>0.87476515888799999</c:v>
                </c:pt>
                <c:pt idx="10">
                  <c:v>0.70048690248599998</c:v>
                </c:pt>
                <c:pt idx="11">
                  <c:v>0.23457569770700001</c:v>
                </c:pt>
                <c:pt idx="12">
                  <c:v>0.27078815830000003</c:v>
                </c:pt>
                <c:pt idx="13">
                  <c:v>0.80176211453699997</c:v>
                </c:pt>
                <c:pt idx="14">
                  <c:v>0.88076156074800005</c:v>
                </c:pt>
                <c:pt idx="15">
                  <c:v>0.90699063461100005</c:v>
                </c:pt>
                <c:pt idx="16">
                  <c:v>0.50518513732699999</c:v>
                </c:pt>
                <c:pt idx="17">
                  <c:v>0.30132552312900002</c:v>
                </c:pt>
                <c:pt idx="18">
                  <c:v>0.44842024512899997</c:v>
                </c:pt>
                <c:pt idx="19">
                  <c:v>0.94181035436399996</c:v>
                </c:pt>
                <c:pt idx="20">
                  <c:v>0.95676447448599999</c:v>
                </c:pt>
                <c:pt idx="21">
                  <c:v>0.249494003849</c:v>
                </c:pt>
                <c:pt idx="22">
                  <c:v>0.85735827569800005</c:v>
                </c:pt>
                <c:pt idx="23">
                  <c:v>0.99685821228399996</c:v>
                </c:pt>
                <c:pt idx="24">
                  <c:v>0.60333201069999998</c:v>
                </c:pt>
                <c:pt idx="25">
                  <c:v>0.535315261855</c:v>
                </c:pt>
                <c:pt idx="26">
                  <c:v>0.55980225368100001</c:v>
                </c:pt>
                <c:pt idx="27">
                  <c:v>0.764833974079</c:v>
                </c:pt>
                <c:pt idx="28">
                  <c:v>1</c:v>
                </c:pt>
                <c:pt idx="29">
                  <c:v>0.98608864445199995</c:v>
                </c:pt>
                <c:pt idx="30">
                  <c:v>0.19018500611200001</c:v>
                </c:pt>
                <c:pt idx="31">
                  <c:v>7.2859019152800006E-2</c:v>
                </c:pt>
                <c:pt idx="32">
                  <c:v>0.86683451745499995</c:v>
                </c:pt>
                <c:pt idx="33">
                  <c:v>0.96323538810099996</c:v>
                </c:pt>
                <c:pt idx="34">
                  <c:v>0.66898337600199997</c:v>
                </c:pt>
                <c:pt idx="35">
                  <c:v>0.14840754711900001</c:v>
                </c:pt>
                <c:pt idx="36">
                  <c:v>0.28792242930099998</c:v>
                </c:pt>
                <c:pt idx="37">
                  <c:v>0.60058668136100002</c:v>
                </c:pt>
                <c:pt idx="38">
                  <c:v>0.31864809336299998</c:v>
                </c:pt>
                <c:pt idx="39">
                  <c:v>0.28216072519500002</c:v>
                </c:pt>
                <c:pt idx="40">
                  <c:v>0.48904561241700001</c:v>
                </c:pt>
                <c:pt idx="41">
                  <c:v>5.4423480403599997E-2</c:v>
                </c:pt>
                <c:pt idx="42">
                  <c:v>2.78969168009E-2</c:v>
                </c:pt>
                <c:pt idx="43">
                  <c:v>0.22725531676499999</c:v>
                </c:pt>
                <c:pt idx="44">
                  <c:v>0.50638088302499995</c:v>
                </c:pt>
                <c:pt idx="45">
                  <c:v>0.71959832865700002</c:v>
                </c:pt>
                <c:pt idx="46">
                  <c:v>0.55063252109000005</c:v>
                </c:pt>
                <c:pt idx="47">
                  <c:v>0.34785874227300001</c:v>
                </c:pt>
                <c:pt idx="48">
                  <c:v>1.3088341151899999E-2</c:v>
                </c:pt>
                <c:pt idx="49">
                  <c:v>0.36257420782900002</c:v>
                </c:pt>
                <c:pt idx="50">
                  <c:v>0.60339440724100002</c:v>
                </c:pt>
                <c:pt idx="51">
                  <c:v>3.8768794003900001E-2</c:v>
                </c:pt>
                <c:pt idx="52">
                  <c:v>0.37238045403800002</c:v>
                </c:pt>
                <c:pt idx="53">
                  <c:v>0.14053971042899999</c:v>
                </c:pt>
                <c:pt idx="54">
                  <c:v>9.6157823156399994E-2</c:v>
                </c:pt>
                <c:pt idx="55">
                  <c:v>8.5301944019900003E-2</c:v>
                </c:pt>
                <c:pt idx="56">
                  <c:v>0.10399740943499999</c:v>
                </c:pt>
                <c:pt idx="57">
                  <c:v>0.33846962213999998</c:v>
                </c:pt>
                <c:pt idx="58">
                  <c:v>0.36052981149899999</c:v>
                </c:pt>
                <c:pt idx="59">
                  <c:v>0.35138100962899999</c:v>
                </c:pt>
                <c:pt idx="60">
                  <c:v>0.15209620357600001</c:v>
                </c:pt>
                <c:pt idx="61">
                  <c:v>0.303227944601</c:v>
                </c:pt>
                <c:pt idx="62">
                  <c:v>0.28127541271099998</c:v>
                </c:pt>
                <c:pt idx="63">
                  <c:v>0.50147271932100002</c:v>
                </c:pt>
                <c:pt idx="64">
                  <c:v>0.93228290804500002</c:v>
                </c:pt>
                <c:pt idx="65">
                  <c:v>0.73164037369199997</c:v>
                </c:pt>
                <c:pt idx="66">
                  <c:v>0.94173419824100002</c:v>
                </c:pt>
                <c:pt idx="67">
                  <c:v>0.45567409705700002</c:v>
                </c:pt>
                <c:pt idx="68">
                  <c:v>7.3423637464300001E-2</c:v>
                </c:pt>
                <c:pt idx="69">
                  <c:v>0.25643808456700001</c:v>
                </c:pt>
                <c:pt idx="70">
                  <c:v>0.24513721120500001</c:v>
                </c:pt>
                <c:pt idx="71">
                  <c:v>0.829520013256</c:v>
                </c:pt>
                <c:pt idx="72">
                  <c:v>5.99729230298E-2</c:v>
                </c:pt>
                <c:pt idx="73">
                  <c:v>0.69581756283200002</c:v>
                </c:pt>
                <c:pt idx="74">
                  <c:v>0.94802679380499999</c:v>
                </c:pt>
                <c:pt idx="75">
                  <c:v>0</c:v>
                </c:pt>
                <c:pt idx="76">
                  <c:v>1.1173031494300001E-3</c:v>
                </c:pt>
                <c:pt idx="77">
                  <c:v>1.3952777066599999E-2</c:v>
                </c:pt>
                <c:pt idx="78">
                  <c:v>0.38685079065700001</c:v>
                </c:pt>
                <c:pt idx="79">
                  <c:v>4.13125590179E-2</c:v>
                </c:pt>
                <c:pt idx="80">
                  <c:v>1.2585812768400001E-3</c:v>
                </c:pt>
                <c:pt idx="81">
                  <c:v>0.68307294436300003</c:v>
                </c:pt>
                <c:pt idx="82">
                  <c:v>2.5974706311200002E-3</c:v>
                </c:pt>
                <c:pt idx="83">
                  <c:v>0.72418136020199997</c:v>
                </c:pt>
                <c:pt idx="84">
                  <c:v>5.2692694190300003E-2</c:v>
                </c:pt>
                <c:pt idx="85">
                  <c:v>0.114681676055</c:v>
                </c:pt>
                <c:pt idx="86">
                  <c:v>0.32118395518499998</c:v>
                </c:pt>
                <c:pt idx="87">
                  <c:v>0.13972146787600001</c:v>
                </c:pt>
                <c:pt idx="88">
                  <c:v>1.02739660749E-2</c:v>
                </c:pt>
                <c:pt idx="89">
                  <c:v>9.7124797656699999E-2</c:v>
                </c:pt>
                <c:pt idx="90">
                  <c:v>0.24880035264299999</c:v>
                </c:pt>
                <c:pt idx="91">
                  <c:v>0.46521872186800001</c:v>
                </c:pt>
                <c:pt idx="92">
                  <c:v>0.61642677049100003</c:v>
                </c:pt>
                <c:pt idx="93">
                  <c:v>0.294076059931</c:v>
                </c:pt>
                <c:pt idx="94">
                  <c:v>1.1042718600300001E-2</c:v>
                </c:pt>
                <c:pt idx="95">
                  <c:v>4.37790935836E-2</c:v>
                </c:pt>
                <c:pt idx="96">
                  <c:v>2.70717707245E-2</c:v>
                </c:pt>
                <c:pt idx="97">
                  <c:v>7.3152493395100002E-3</c:v>
                </c:pt>
                <c:pt idx="98">
                  <c:v>0.14314660827100001</c:v>
                </c:pt>
                <c:pt idx="99">
                  <c:v>0.69251219227399996</c:v>
                </c:pt>
                <c:pt idx="100">
                  <c:v>5.35838689379E-2</c:v>
                </c:pt>
                <c:pt idx="101">
                  <c:v>0.17850865280600001</c:v>
                </c:pt>
                <c:pt idx="102">
                  <c:v>0.14175880329500001</c:v>
                </c:pt>
                <c:pt idx="103">
                  <c:v>0.22408785431100001</c:v>
                </c:pt>
                <c:pt idx="104">
                  <c:v>1.1277227252399999E-2</c:v>
                </c:pt>
                <c:pt idx="105">
                  <c:v>5.7778413403899997E-2</c:v>
                </c:pt>
                <c:pt idx="106">
                  <c:v>1.11237125201E-2</c:v>
                </c:pt>
                <c:pt idx="107">
                  <c:v>1.7877608203900001E-2</c:v>
                </c:pt>
                <c:pt idx="108">
                  <c:v>6.4763194151599996E-3</c:v>
                </c:pt>
                <c:pt idx="109">
                  <c:v>0.62992103231200003</c:v>
                </c:pt>
                <c:pt idx="110">
                  <c:v>0.35342608108700002</c:v>
                </c:pt>
                <c:pt idx="111">
                  <c:v>1.6071110955900001E-2</c:v>
                </c:pt>
                <c:pt idx="112">
                  <c:v>0.20714882438900001</c:v>
                </c:pt>
                <c:pt idx="113">
                  <c:v>4.14714016269E-3</c:v>
                </c:pt>
                <c:pt idx="114">
                  <c:v>0.25408842179500002</c:v>
                </c:pt>
                <c:pt idx="115">
                  <c:v>3.74415716833E-2</c:v>
                </c:pt>
                <c:pt idx="116">
                  <c:v>0.46235502260700001</c:v>
                </c:pt>
                <c:pt idx="117">
                  <c:v>4.4980847918599999E-2</c:v>
                </c:pt>
                <c:pt idx="118">
                  <c:v>2.06990039894E-2</c:v>
                </c:pt>
                <c:pt idx="119">
                  <c:v>9.3797782260699999E-2</c:v>
                </c:pt>
                <c:pt idx="120">
                  <c:v>3.6749314483899998E-3</c:v>
                </c:pt>
                <c:pt idx="121">
                  <c:v>1.7664064100500001E-2</c:v>
                </c:pt>
                <c:pt idx="122">
                  <c:v>0.38310379002799999</c:v>
                </c:pt>
                <c:pt idx="123">
                  <c:v>0.91477761687900006</c:v>
                </c:pt>
                <c:pt idx="124">
                  <c:v>0.25826353202399999</c:v>
                </c:pt>
                <c:pt idx="125">
                  <c:v>0.303321626427</c:v>
                </c:pt>
                <c:pt idx="126">
                  <c:v>0.336068839648</c:v>
                </c:pt>
                <c:pt idx="127">
                  <c:v>0.35637244529899997</c:v>
                </c:pt>
                <c:pt idx="128">
                  <c:v>0.50162409862000001</c:v>
                </c:pt>
                <c:pt idx="129">
                  <c:v>0.58195793764199999</c:v>
                </c:pt>
                <c:pt idx="130">
                  <c:v>6.5765436609399999E-2</c:v>
                </c:pt>
                <c:pt idx="131">
                  <c:v>0.42909230297700002</c:v>
                </c:pt>
                <c:pt idx="132">
                  <c:v>0.925659212201</c:v>
                </c:pt>
                <c:pt idx="133">
                  <c:v>0.121186630039</c:v>
                </c:pt>
                <c:pt idx="134">
                  <c:v>4.2297776345500001E-4</c:v>
                </c:pt>
                <c:pt idx="135">
                  <c:v>5.7165114933399999E-2</c:v>
                </c:pt>
                <c:pt idx="136">
                  <c:v>5.8075951938599997E-2</c:v>
                </c:pt>
                <c:pt idx="137">
                  <c:v>0.14343177270499999</c:v>
                </c:pt>
                <c:pt idx="138">
                  <c:v>4.8470859780700003E-2</c:v>
                </c:pt>
                <c:pt idx="139">
                  <c:v>5.3401144310200002E-2</c:v>
                </c:pt>
                <c:pt idx="140">
                  <c:v>0.41042739224500002</c:v>
                </c:pt>
                <c:pt idx="141">
                  <c:v>9.60947538969E-3</c:v>
                </c:pt>
                <c:pt idx="142">
                  <c:v>0.71192090638200001</c:v>
                </c:pt>
                <c:pt idx="143">
                  <c:v>0.12735239945099999</c:v>
                </c:pt>
                <c:pt idx="144">
                  <c:v>2.7657902949800001E-2</c:v>
                </c:pt>
                <c:pt idx="145">
                  <c:v>0.70968289431499998</c:v>
                </c:pt>
                <c:pt idx="146">
                  <c:v>7.2657125986300003E-3</c:v>
                </c:pt>
                <c:pt idx="147">
                  <c:v>0.46244778936399999</c:v>
                </c:pt>
                <c:pt idx="148">
                  <c:v>5.7740575136400003E-3</c:v>
                </c:pt>
                <c:pt idx="149">
                  <c:v>2.3569617802999998E-3</c:v>
                </c:pt>
                <c:pt idx="150">
                  <c:v>5.7358234372299997E-2</c:v>
                </c:pt>
                <c:pt idx="151">
                  <c:v>4.5405562210599999E-2</c:v>
                </c:pt>
                <c:pt idx="152">
                  <c:v>0.15943609632700001</c:v>
                </c:pt>
                <c:pt idx="153">
                  <c:v>2.5738802794499999E-2</c:v>
                </c:pt>
                <c:pt idx="154">
                  <c:v>4.0695590370399999E-2</c:v>
                </c:pt>
                <c:pt idx="155">
                  <c:v>0.141543843797</c:v>
                </c:pt>
                <c:pt idx="156">
                  <c:v>5.3717305557399999E-3</c:v>
                </c:pt>
                <c:pt idx="157">
                  <c:v>0.29076993018399999</c:v>
                </c:pt>
                <c:pt idx="158">
                  <c:v>6.1379637670900003E-2</c:v>
                </c:pt>
                <c:pt idx="159">
                  <c:v>0.56460385861899998</c:v>
                </c:pt>
                <c:pt idx="160">
                  <c:v>0.32893366804099999</c:v>
                </c:pt>
                <c:pt idx="161">
                  <c:v>0.307010800689</c:v>
                </c:pt>
                <c:pt idx="162">
                  <c:v>1.4454541063500001E-3</c:v>
                </c:pt>
                <c:pt idx="163">
                  <c:v>6.7113104017899994E-2</c:v>
                </c:pt>
                <c:pt idx="164">
                  <c:v>3.5133875751400002E-4</c:v>
                </c:pt>
                <c:pt idx="165">
                  <c:v>0.13150930519000001</c:v>
                </c:pt>
                <c:pt idx="166">
                  <c:v>0.31721231992100002</c:v>
                </c:pt>
                <c:pt idx="167">
                  <c:v>1.28330349131E-2</c:v>
                </c:pt>
                <c:pt idx="168">
                  <c:v>3.1756955148399997E-2</c:v>
                </c:pt>
                <c:pt idx="169">
                  <c:v>0.34712063473400001</c:v>
                </c:pt>
                <c:pt idx="170">
                  <c:v>0.50635832869899999</c:v>
                </c:pt>
                <c:pt idx="171">
                  <c:v>3.5081376721E-2</c:v>
                </c:pt>
                <c:pt idx="172">
                  <c:v>6.7292979803299999E-3</c:v>
                </c:pt>
                <c:pt idx="173">
                  <c:v>1.6870094509200001E-3</c:v>
                </c:pt>
                <c:pt idx="174">
                  <c:v>0.21864861873899999</c:v>
                </c:pt>
                <c:pt idx="175">
                  <c:v>1.3075182554700001E-2</c:v>
                </c:pt>
                <c:pt idx="176">
                  <c:v>0.26268740346399999</c:v>
                </c:pt>
                <c:pt idx="177">
                  <c:v>6.5830579126899995E-4</c:v>
                </c:pt>
                <c:pt idx="178">
                  <c:v>7.6778524956400002E-2</c:v>
                </c:pt>
                <c:pt idx="179">
                  <c:v>0.50650535528999996</c:v>
                </c:pt>
                <c:pt idx="180">
                  <c:v>8.6684323737200003E-2</c:v>
                </c:pt>
                <c:pt idx="181">
                  <c:v>0.175658549266</c:v>
                </c:pt>
                <c:pt idx="182">
                  <c:v>3.8133867959999998E-2</c:v>
                </c:pt>
                <c:pt idx="183">
                  <c:v>1.90283347715E-2</c:v>
                </c:pt>
                <c:pt idx="184">
                  <c:v>0.18467624460000001</c:v>
                </c:pt>
                <c:pt idx="185">
                  <c:v>2.0530131149399999E-2</c:v>
                </c:pt>
                <c:pt idx="186">
                  <c:v>9.7792199114200007E-2</c:v>
                </c:pt>
                <c:pt idx="187">
                  <c:v>0</c:v>
                </c:pt>
                <c:pt idx="188">
                  <c:v>0.34346786523599998</c:v>
                </c:pt>
                <c:pt idx="189">
                  <c:v>0.19836005099199999</c:v>
                </c:pt>
                <c:pt idx="190">
                  <c:v>8.1655145194899997E-2</c:v>
                </c:pt>
                <c:pt idx="191">
                  <c:v>0.76570202518200003</c:v>
                </c:pt>
                <c:pt idx="192">
                  <c:v>0.27303049317099998</c:v>
                </c:pt>
                <c:pt idx="193">
                  <c:v>7.3029577720599995E-2</c:v>
                </c:pt>
                <c:pt idx="194">
                  <c:v>4.1866034360399998E-2</c:v>
                </c:pt>
                <c:pt idx="195">
                  <c:v>0.593631318016</c:v>
                </c:pt>
                <c:pt idx="196">
                  <c:v>0.174936312042</c:v>
                </c:pt>
                <c:pt idx="197">
                  <c:v>0.17718150197499999</c:v>
                </c:pt>
                <c:pt idx="198">
                  <c:v>0.38176375277199998</c:v>
                </c:pt>
                <c:pt idx="199">
                  <c:v>6.4834104102499998E-2</c:v>
                </c:pt>
                <c:pt idx="200">
                  <c:v>9.0569642236900005E-2</c:v>
                </c:pt>
                <c:pt idx="201">
                  <c:v>1.54977021691E-2</c:v>
                </c:pt>
                <c:pt idx="202">
                  <c:v>1.86965811966E-2</c:v>
                </c:pt>
                <c:pt idx="203">
                  <c:v>8.8168642567200001E-3</c:v>
                </c:pt>
                <c:pt idx="204">
                  <c:v>1.45066247829E-3</c:v>
                </c:pt>
                <c:pt idx="205">
                  <c:v>2.92604020167E-2</c:v>
                </c:pt>
                <c:pt idx="206">
                  <c:v>4.7786540554299997E-2</c:v>
                </c:pt>
                <c:pt idx="207">
                  <c:v>5.3603093790700003E-2</c:v>
                </c:pt>
                <c:pt idx="208">
                  <c:v>4.9644425977499997E-2</c:v>
                </c:pt>
                <c:pt idx="209">
                  <c:v>0.10072806983599999</c:v>
                </c:pt>
                <c:pt idx="210">
                  <c:v>1.0791306031E-2</c:v>
                </c:pt>
                <c:pt idx="211">
                  <c:v>6.2037197820799996E-3</c:v>
                </c:pt>
                <c:pt idx="212">
                  <c:v>7.8445088129699997E-2</c:v>
                </c:pt>
                <c:pt idx="213">
                  <c:v>2.77965545859E-2</c:v>
                </c:pt>
                <c:pt idx="214">
                  <c:v>7.8567509047899997E-2</c:v>
                </c:pt>
                <c:pt idx="215">
                  <c:v>0.2113921973</c:v>
                </c:pt>
                <c:pt idx="216">
                  <c:v>0.139720425565</c:v>
                </c:pt>
                <c:pt idx="217">
                  <c:v>0.10115979895799999</c:v>
                </c:pt>
                <c:pt idx="218">
                  <c:v>0.12466931998399999</c:v>
                </c:pt>
                <c:pt idx="219">
                  <c:v>0.102125856443</c:v>
                </c:pt>
                <c:pt idx="220">
                  <c:v>0.121977528409</c:v>
                </c:pt>
                <c:pt idx="221">
                  <c:v>0.15633870319400001</c:v>
                </c:pt>
                <c:pt idx="222">
                  <c:v>0.36703996641699999</c:v>
                </c:pt>
                <c:pt idx="223">
                  <c:v>9.8703987306600002E-2</c:v>
                </c:pt>
                <c:pt idx="224">
                  <c:v>0.10467327762</c:v>
                </c:pt>
                <c:pt idx="225">
                  <c:v>8.4448920595999996E-2</c:v>
                </c:pt>
                <c:pt idx="226">
                  <c:v>8.6937640307599998E-2</c:v>
                </c:pt>
                <c:pt idx="227">
                  <c:v>7.6914591868899998E-2</c:v>
                </c:pt>
                <c:pt idx="228">
                  <c:v>9.5271066268699994E-2</c:v>
                </c:pt>
                <c:pt idx="229">
                  <c:v>8.5408049058899996E-2</c:v>
                </c:pt>
                <c:pt idx="230">
                  <c:v>8.5200953701900006E-2</c:v>
                </c:pt>
                <c:pt idx="231">
                  <c:v>8.5974261498399998E-2</c:v>
                </c:pt>
                <c:pt idx="232">
                  <c:v>9.1062115617899994E-2</c:v>
                </c:pt>
                <c:pt idx="233">
                  <c:v>8.5484538657600001E-2</c:v>
                </c:pt>
                <c:pt idx="234">
                  <c:v>9.7684292840800005E-2</c:v>
                </c:pt>
                <c:pt idx="235">
                  <c:v>7.8456385217400004E-2</c:v>
                </c:pt>
                <c:pt idx="236">
                  <c:v>6.1535520170400003E-2</c:v>
                </c:pt>
                <c:pt idx="237">
                  <c:v>5.6839682680000003E-2</c:v>
                </c:pt>
                <c:pt idx="238">
                  <c:v>6.2020753332200002E-2</c:v>
                </c:pt>
                <c:pt idx="239">
                  <c:v>7.2567756721999999E-2</c:v>
                </c:pt>
                <c:pt idx="240">
                  <c:v>7.3363602915000006E-2</c:v>
                </c:pt>
                <c:pt idx="241">
                  <c:v>8.6469388999100005E-2</c:v>
                </c:pt>
                <c:pt idx="242">
                  <c:v>7.5296070707700002E-2</c:v>
                </c:pt>
                <c:pt idx="243">
                  <c:v>5.589113498300000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2084864"/>
        <c:axId val="452293376"/>
      </c:barChart>
      <c:catAx>
        <c:axId val="4520848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Samples</a:t>
                </a:r>
              </a:p>
            </c:rich>
          </c:tx>
          <c:layout>
            <c:manualLayout>
              <c:xMode val="edge"/>
              <c:yMode val="edge"/>
              <c:x val="0.4927394736842105"/>
              <c:y val="0.90754076479076484"/>
            </c:manualLayout>
          </c:layout>
          <c:overlay val="0"/>
        </c:title>
        <c:majorTickMark val="none"/>
        <c:minorTickMark val="none"/>
        <c:tickLblPos val="nextTo"/>
        <c:crossAx val="452293376"/>
        <c:crosses val="autoZero"/>
        <c:auto val="1"/>
        <c:lblAlgn val="ctr"/>
        <c:lblOffset val="100"/>
        <c:noMultiLvlLbl val="0"/>
      </c:catAx>
      <c:valAx>
        <c:axId val="452293376"/>
        <c:scaling>
          <c:orientation val="minMax"/>
          <c:max val="1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altLang="zh-CN" sz="1200"/>
                  <a:t>Percent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52084864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10101" y="2796185"/>
            <a:ext cx="9181148" cy="192940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620204" y="5100638"/>
            <a:ext cx="7560945" cy="230028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760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521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28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042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564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0325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6085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830979" y="360464"/>
            <a:ext cx="2430304" cy="768012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40068" y="360464"/>
            <a:ext cx="7110889" cy="7680126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53232" y="5784058"/>
            <a:ext cx="9181148" cy="1787724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53232" y="3815062"/>
            <a:ext cx="9181148" cy="1968996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76072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2pPr>
            <a:lvl3pPr marL="115214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72821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30428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88036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45643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403250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60857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40068" y="2100263"/>
            <a:ext cx="4770596" cy="5940327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490686" y="2100263"/>
            <a:ext cx="4770596" cy="5940327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0068" y="2014837"/>
            <a:ext cx="4772472" cy="839687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72" indent="0">
              <a:buNone/>
              <a:defRPr sz="2500" b="1"/>
            </a:lvl2pPr>
            <a:lvl3pPr marL="1152144" indent="0">
              <a:buNone/>
              <a:defRPr sz="2300" b="1"/>
            </a:lvl3pPr>
            <a:lvl4pPr marL="1728216" indent="0">
              <a:buNone/>
              <a:defRPr sz="2000" b="1"/>
            </a:lvl4pPr>
            <a:lvl5pPr marL="2304288" indent="0">
              <a:buNone/>
              <a:defRPr sz="2000" b="1"/>
            </a:lvl5pPr>
            <a:lvl6pPr marL="2880360" indent="0">
              <a:buNone/>
              <a:defRPr sz="2000" b="1"/>
            </a:lvl6pPr>
            <a:lvl7pPr marL="3456432" indent="0">
              <a:buNone/>
              <a:defRPr sz="2000" b="1"/>
            </a:lvl7pPr>
            <a:lvl8pPr marL="4032504" indent="0">
              <a:buNone/>
              <a:defRPr sz="2000" b="1"/>
            </a:lvl8pPr>
            <a:lvl9pPr marL="4608576" indent="0">
              <a:buNone/>
              <a:defRPr sz="20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40068" y="2854523"/>
            <a:ext cx="4772472" cy="5186066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486938" y="2014837"/>
            <a:ext cx="4774347" cy="839687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72" indent="0">
              <a:buNone/>
              <a:defRPr sz="2500" b="1"/>
            </a:lvl2pPr>
            <a:lvl3pPr marL="1152144" indent="0">
              <a:buNone/>
              <a:defRPr sz="2300" b="1"/>
            </a:lvl3pPr>
            <a:lvl4pPr marL="1728216" indent="0">
              <a:buNone/>
              <a:defRPr sz="2000" b="1"/>
            </a:lvl4pPr>
            <a:lvl5pPr marL="2304288" indent="0">
              <a:buNone/>
              <a:defRPr sz="2000" b="1"/>
            </a:lvl5pPr>
            <a:lvl6pPr marL="2880360" indent="0">
              <a:buNone/>
              <a:defRPr sz="2000" b="1"/>
            </a:lvl6pPr>
            <a:lvl7pPr marL="3456432" indent="0">
              <a:buNone/>
              <a:defRPr sz="2000" b="1"/>
            </a:lvl7pPr>
            <a:lvl8pPr marL="4032504" indent="0">
              <a:buNone/>
              <a:defRPr sz="2000" b="1"/>
            </a:lvl8pPr>
            <a:lvl9pPr marL="4608576" indent="0">
              <a:buNone/>
              <a:defRPr sz="20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486938" y="2854523"/>
            <a:ext cx="4774347" cy="5186066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0069" y="358380"/>
            <a:ext cx="3553570" cy="1525190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223029" y="358380"/>
            <a:ext cx="6038255" cy="7682210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40069" y="1883569"/>
            <a:ext cx="3553570" cy="6157020"/>
          </a:xfrm>
        </p:spPr>
        <p:txBody>
          <a:bodyPr/>
          <a:lstStyle>
            <a:lvl1pPr marL="0" indent="0">
              <a:buNone/>
              <a:defRPr sz="1800"/>
            </a:lvl1pPr>
            <a:lvl2pPr marL="576072" indent="0">
              <a:buNone/>
              <a:defRPr sz="1500"/>
            </a:lvl2pPr>
            <a:lvl3pPr marL="1152144" indent="0">
              <a:buNone/>
              <a:defRPr sz="1300"/>
            </a:lvl3pPr>
            <a:lvl4pPr marL="1728216" indent="0">
              <a:buNone/>
              <a:defRPr sz="1100"/>
            </a:lvl4pPr>
            <a:lvl5pPr marL="2304288" indent="0">
              <a:buNone/>
              <a:defRPr sz="1100"/>
            </a:lvl5pPr>
            <a:lvl6pPr marL="2880360" indent="0">
              <a:buNone/>
              <a:defRPr sz="1100"/>
            </a:lvl6pPr>
            <a:lvl7pPr marL="3456432" indent="0">
              <a:buNone/>
              <a:defRPr sz="1100"/>
            </a:lvl7pPr>
            <a:lvl8pPr marL="4032504" indent="0">
              <a:buNone/>
              <a:defRPr sz="1100"/>
            </a:lvl8pPr>
            <a:lvl9pPr marL="4608576" indent="0">
              <a:buNone/>
              <a:defRPr sz="11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117140" y="6300789"/>
            <a:ext cx="6480810" cy="743844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117140" y="804268"/>
            <a:ext cx="6480810" cy="5400675"/>
          </a:xfrm>
        </p:spPr>
        <p:txBody>
          <a:bodyPr/>
          <a:lstStyle>
            <a:lvl1pPr marL="0" indent="0">
              <a:buNone/>
              <a:defRPr sz="4000"/>
            </a:lvl1pPr>
            <a:lvl2pPr marL="576072" indent="0">
              <a:buNone/>
              <a:defRPr sz="3500"/>
            </a:lvl2pPr>
            <a:lvl3pPr marL="1152144" indent="0">
              <a:buNone/>
              <a:defRPr sz="3000"/>
            </a:lvl3pPr>
            <a:lvl4pPr marL="1728216" indent="0">
              <a:buNone/>
              <a:defRPr sz="2500"/>
            </a:lvl4pPr>
            <a:lvl5pPr marL="2304288" indent="0">
              <a:buNone/>
              <a:defRPr sz="2500"/>
            </a:lvl5pPr>
            <a:lvl6pPr marL="2880360" indent="0">
              <a:buNone/>
              <a:defRPr sz="2500"/>
            </a:lvl6pPr>
            <a:lvl7pPr marL="3456432" indent="0">
              <a:buNone/>
              <a:defRPr sz="2500"/>
            </a:lvl7pPr>
            <a:lvl8pPr marL="4032504" indent="0">
              <a:buNone/>
              <a:defRPr sz="2500"/>
            </a:lvl8pPr>
            <a:lvl9pPr marL="4608576" indent="0">
              <a:buNone/>
              <a:defRPr sz="2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117140" y="7044632"/>
            <a:ext cx="6480810" cy="1056381"/>
          </a:xfrm>
        </p:spPr>
        <p:txBody>
          <a:bodyPr/>
          <a:lstStyle>
            <a:lvl1pPr marL="0" indent="0">
              <a:buNone/>
              <a:defRPr sz="1800"/>
            </a:lvl1pPr>
            <a:lvl2pPr marL="576072" indent="0">
              <a:buNone/>
              <a:defRPr sz="1500"/>
            </a:lvl2pPr>
            <a:lvl3pPr marL="1152144" indent="0">
              <a:buNone/>
              <a:defRPr sz="1300"/>
            </a:lvl3pPr>
            <a:lvl4pPr marL="1728216" indent="0">
              <a:buNone/>
              <a:defRPr sz="1100"/>
            </a:lvl4pPr>
            <a:lvl5pPr marL="2304288" indent="0">
              <a:buNone/>
              <a:defRPr sz="1100"/>
            </a:lvl5pPr>
            <a:lvl6pPr marL="2880360" indent="0">
              <a:buNone/>
              <a:defRPr sz="1100"/>
            </a:lvl6pPr>
            <a:lvl7pPr marL="3456432" indent="0">
              <a:buNone/>
              <a:defRPr sz="1100"/>
            </a:lvl7pPr>
            <a:lvl8pPr marL="4032504" indent="0">
              <a:buNone/>
              <a:defRPr sz="1100"/>
            </a:lvl8pPr>
            <a:lvl9pPr marL="4608576" indent="0">
              <a:buNone/>
              <a:defRPr sz="11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540069" y="360462"/>
            <a:ext cx="9721215" cy="1500188"/>
          </a:xfrm>
          <a:prstGeom prst="rect">
            <a:avLst/>
          </a:prstGeom>
        </p:spPr>
        <p:txBody>
          <a:bodyPr vert="horz" lIns="115214" tIns="57607" rIns="115214" bIns="57607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0069" y="2100263"/>
            <a:ext cx="9721215" cy="5940327"/>
          </a:xfrm>
          <a:prstGeom prst="rect">
            <a:avLst/>
          </a:prstGeom>
        </p:spPr>
        <p:txBody>
          <a:bodyPr vert="horz" lIns="115214" tIns="57607" rIns="115214" bIns="57607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540067" y="8342713"/>
            <a:ext cx="2520315" cy="479226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3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690461" y="8342713"/>
            <a:ext cx="3420428" cy="479226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7740969" y="8342713"/>
            <a:ext cx="2520315" cy="479226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52144" rtl="0" eaLnBrk="1" latinLnBrk="0" hangingPunct="1">
        <a:spcBef>
          <a:spcPct val="0"/>
        </a:spcBef>
        <a:buNone/>
        <a:defRPr sz="5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2054" indent="-432054" algn="l" defTabSz="1152144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1pPr>
      <a:lvl2pPr marL="936117" indent="-360045" algn="l" defTabSz="1152144" rtl="0" eaLnBrk="1" latinLnBrk="0" hangingPunct="1">
        <a:spcBef>
          <a:spcPct val="20000"/>
        </a:spcBef>
        <a:buFont typeface="Arial" pitchFamily="34" charset="0"/>
        <a:buChar char="–"/>
        <a:defRPr sz="3500" kern="1200">
          <a:solidFill>
            <a:schemeClr val="tx1"/>
          </a:solidFill>
          <a:latin typeface="+mn-lt"/>
          <a:ea typeface="+mn-ea"/>
          <a:cs typeface="+mn-cs"/>
        </a:defRPr>
      </a:lvl2pPr>
      <a:lvl3pPr marL="1440180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016252" indent="-288036" algn="l" defTabSz="1152144" rtl="0" eaLnBrk="1" latinLnBrk="0" hangingPunct="1">
        <a:spcBef>
          <a:spcPct val="20000"/>
        </a:spcBef>
        <a:buFont typeface="Arial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92324" indent="-288036" algn="l" defTabSz="1152144" rtl="0" eaLnBrk="1" latinLnBrk="0" hangingPunct="1">
        <a:spcBef>
          <a:spcPct val="20000"/>
        </a:spcBef>
        <a:buFont typeface="Arial" pitchFamily="34" charset="0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68396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44468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320540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896612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76072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152144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728216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04288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80360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456432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4032504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608576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图表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161045"/>
              </p:ext>
            </p:extLst>
          </p:nvPr>
        </p:nvGraphicFramePr>
        <p:xfrm>
          <a:off x="270675" y="108074"/>
          <a:ext cx="10260000" cy="27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图表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7633559"/>
              </p:ext>
            </p:extLst>
          </p:nvPr>
        </p:nvGraphicFramePr>
        <p:xfrm>
          <a:off x="270675" y="3078435"/>
          <a:ext cx="10260000" cy="27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图表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9319843"/>
              </p:ext>
            </p:extLst>
          </p:nvPr>
        </p:nvGraphicFramePr>
        <p:xfrm>
          <a:off x="270675" y="6048796"/>
          <a:ext cx="10260000" cy="27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512792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自定义</PresentationFormat>
  <Paragraphs>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pad</dc:creator>
  <cp:lastModifiedBy>Thinkpad</cp:lastModifiedBy>
  <cp:revision>1</cp:revision>
  <dcterms:created xsi:type="dcterms:W3CDTF">2023-07-04T04:07:18Z</dcterms:created>
  <dcterms:modified xsi:type="dcterms:W3CDTF">2023-07-04T04:11:07Z</dcterms:modified>
</cp:coreProperties>
</file>